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82" r:id="rId2"/>
    <p:sldId id="289" r:id="rId3"/>
    <p:sldId id="299" r:id="rId4"/>
    <p:sldId id="271" r:id="rId5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837"/>
    <p:restoredTop sz="94558"/>
  </p:normalViewPr>
  <p:slideViewPr>
    <p:cSldViewPr snapToGrid="0" snapToObjects="1">
      <p:cViewPr>
        <p:scale>
          <a:sx n="314" d="100"/>
          <a:sy n="314" d="100"/>
        </p:scale>
        <p:origin x="-896" y="-18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/Users/TomohiroEnokida/Desktop/20190418_IC-PCE&#26368;&#32066;&#35299;&#26512;(&#20316;&#22259;&#29992;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omohiroEnokida/Desktop/20190418_IC-PCE&#26368;&#32066;&#35299;&#26512;(&#20316;&#22259;&#29992;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omohiroEnokida/Desktop/20190418_IC-PCE&#26368;&#32066;&#35299;&#26512;(&#20316;&#22259;&#29992;)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omohiroEnokida/Desktop/20190418_IC-PCE&#26368;&#32066;&#35299;&#26512;(&#20316;&#22259;&#29992;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20436817472701"/>
          <c:y val="4.80481889551337E-2"/>
          <c:w val="0.81591263650545998"/>
          <c:h val="0.76877102328213998"/>
        </c:manualLayout>
      </c:layout>
      <c:scatterChart>
        <c:scatterStyle val="lineMarker"/>
        <c:varyColors val="0"/>
        <c:ser>
          <c:idx val="0"/>
          <c:order val="0"/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xVal>
            <c:numRef>
              <c:f>SuppFigure2_OS!$A$1:$A$3500</c:f>
              <c:numCache>
                <c:formatCode>General</c:formatCode>
                <c:ptCount val="3500"/>
                <c:pt idx="0">
                  <c:v>0</c:v>
                </c:pt>
                <c:pt idx="1">
                  <c:v>0</c:v>
                </c:pt>
                <c:pt idx="2">
                  <c:v>0.51197809719999998</c:v>
                </c:pt>
                <c:pt idx="3">
                  <c:v>0.51197809719999998</c:v>
                </c:pt>
                <c:pt idx="4">
                  <c:v>1.0732375085999999</c:v>
                </c:pt>
                <c:pt idx="5">
                  <c:v>1.0732375085999999</c:v>
                </c:pt>
                <c:pt idx="6">
                  <c:v>1.1882272415999999</c:v>
                </c:pt>
                <c:pt idx="7">
                  <c:v>1.1882272415999999</c:v>
                </c:pt>
                <c:pt idx="8">
                  <c:v>1.1882272415999999</c:v>
                </c:pt>
                <c:pt idx="9">
                  <c:v>1.2128678986999999</c:v>
                </c:pt>
                <c:pt idx="10">
                  <c:v>1.2128678986999999</c:v>
                </c:pt>
                <c:pt idx="11">
                  <c:v>1.2128678986999999</c:v>
                </c:pt>
                <c:pt idx="12">
                  <c:v>1.2648870637</c:v>
                </c:pt>
                <c:pt idx="13">
                  <c:v>1.2648870637</c:v>
                </c:pt>
                <c:pt idx="14">
                  <c:v>1.2648870637</c:v>
                </c:pt>
                <c:pt idx="15">
                  <c:v>1.28678987</c:v>
                </c:pt>
                <c:pt idx="16">
                  <c:v>1.28678987</c:v>
                </c:pt>
                <c:pt idx="17">
                  <c:v>1.3442847364999999</c:v>
                </c:pt>
                <c:pt idx="18">
                  <c:v>1.3442847364999999</c:v>
                </c:pt>
                <c:pt idx="19">
                  <c:v>1.3442847364999999</c:v>
                </c:pt>
                <c:pt idx="20">
                  <c:v>1.3990417522</c:v>
                </c:pt>
                <c:pt idx="21">
                  <c:v>1.3990417522</c:v>
                </c:pt>
                <c:pt idx="22">
                  <c:v>1.3990417522</c:v>
                </c:pt>
                <c:pt idx="23">
                  <c:v>1.4045174538</c:v>
                </c:pt>
                <c:pt idx="24">
                  <c:v>1.4045174538</c:v>
                </c:pt>
                <c:pt idx="25">
                  <c:v>1.4045174538</c:v>
                </c:pt>
                <c:pt idx="26">
                  <c:v>1.440109514</c:v>
                </c:pt>
                <c:pt idx="27">
                  <c:v>1.440109514</c:v>
                </c:pt>
                <c:pt idx="28">
                  <c:v>1.440109514</c:v>
                </c:pt>
                <c:pt idx="29">
                  <c:v>1.4565366188</c:v>
                </c:pt>
                <c:pt idx="30">
                  <c:v>1.4565366188</c:v>
                </c:pt>
                <c:pt idx="31">
                  <c:v>1.4565366188</c:v>
                </c:pt>
                <c:pt idx="32">
                  <c:v>1.4921286789999999</c:v>
                </c:pt>
                <c:pt idx="33">
                  <c:v>1.4921286789999999</c:v>
                </c:pt>
                <c:pt idx="34">
                  <c:v>1.4921286789999999</c:v>
                </c:pt>
                <c:pt idx="35">
                  <c:v>1.5468856947</c:v>
                </c:pt>
                <c:pt idx="36">
                  <c:v>1.5468856947</c:v>
                </c:pt>
                <c:pt idx="37">
                  <c:v>1.5468856947</c:v>
                </c:pt>
                <c:pt idx="38">
                  <c:v>1.5496235455</c:v>
                </c:pt>
                <c:pt idx="39">
                  <c:v>1.5496235455</c:v>
                </c:pt>
                <c:pt idx="40">
                  <c:v>1.5550992471</c:v>
                </c:pt>
                <c:pt idx="41">
                  <c:v>1.5550992471</c:v>
                </c:pt>
                <c:pt idx="42">
                  <c:v>1.5550992471</c:v>
                </c:pt>
                <c:pt idx="43">
                  <c:v>1.6673511294000001</c:v>
                </c:pt>
                <c:pt idx="44">
                  <c:v>1.6673511294000001</c:v>
                </c:pt>
                <c:pt idx="45">
                  <c:v>1.6673511294000001</c:v>
                </c:pt>
                <c:pt idx="46">
                  <c:v>1.7056810404</c:v>
                </c:pt>
                <c:pt idx="47">
                  <c:v>1.7056810404</c:v>
                </c:pt>
                <c:pt idx="48">
                  <c:v>1.7056810404</c:v>
                </c:pt>
                <c:pt idx="49">
                  <c:v>1.8343600274</c:v>
                </c:pt>
                <c:pt idx="50">
                  <c:v>1.8343600274</c:v>
                </c:pt>
                <c:pt idx="51">
                  <c:v>1.8343600274</c:v>
                </c:pt>
                <c:pt idx="52">
                  <c:v>1.8507871321</c:v>
                </c:pt>
                <c:pt idx="53">
                  <c:v>1.8507871321</c:v>
                </c:pt>
                <c:pt idx="54">
                  <c:v>1.87816564</c:v>
                </c:pt>
                <c:pt idx="55">
                  <c:v>1.87816564</c:v>
                </c:pt>
                <c:pt idx="56">
                  <c:v>1.87816564</c:v>
                </c:pt>
                <c:pt idx="57">
                  <c:v>1.9137577001999999</c:v>
                </c:pt>
                <c:pt idx="58">
                  <c:v>1.9137577001999999</c:v>
                </c:pt>
                <c:pt idx="59">
                  <c:v>1.9137577001999999</c:v>
                </c:pt>
                <c:pt idx="60">
                  <c:v>1.9383983573000001</c:v>
                </c:pt>
                <c:pt idx="61">
                  <c:v>1.9383983573000001</c:v>
                </c:pt>
                <c:pt idx="62">
                  <c:v>1.9383983573000001</c:v>
                </c:pt>
                <c:pt idx="63">
                  <c:v>1.9958932238</c:v>
                </c:pt>
                <c:pt idx="64">
                  <c:v>1.9958932238</c:v>
                </c:pt>
                <c:pt idx="65">
                  <c:v>1.9958932238</c:v>
                </c:pt>
                <c:pt idx="66">
                  <c:v>2.006844627</c:v>
                </c:pt>
                <c:pt idx="67">
                  <c:v>2.006844627</c:v>
                </c:pt>
                <c:pt idx="68">
                  <c:v>2.006844627</c:v>
                </c:pt>
                <c:pt idx="69">
                  <c:v>2.1848049281000002</c:v>
                </c:pt>
                <c:pt idx="70">
                  <c:v>2.1848049281000002</c:v>
                </c:pt>
                <c:pt idx="71">
                  <c:v>2.1848049281000002</c:v>
                </c:pt>
                <c:pt idx="72">
                  <c:v>2.2039698836000001</c:v>
                </c:pt>
                <c:pt idx="73">
                  <c:v>2.2039698836000001</c:v>
                </c:pt>
                <c:pt idx="74">
                  <c:v>2.2039698836000001</c:v>
                </c:pt>
                <c:pt idx="75">
                  <c:v>2.264202601</c:v>
                </c:pt>
                <c:pt idx="76">
                  <c:v>2.264202601</c:v>
                </c:pt>
                <c:pt idx="77">
                  <c:v>2.264202601</c:v>
                </c:pt>
                <c:pt idx="78">
                  <c:v>2.2751540041</c:v>
                </c:pt>
                <c:pt idx="79">
                  <c:v>2.2751540041</c:v>
                </c:pt>
                <c:pt idx="80">
                  <c:v>2.2751540041</c:v>
                </c:pt>
                <c:pt idx="81">
                  <c:v>2.3326488705999782</c:v>
                </c:pt>
                <c:pt idx="82">
                  <c:v>2.3326488705999782</c:v>
                </c:pt>
                <c:pt idx="83">
                  <c:v>2.3326488705999782</c:v>
                </c:pt>
                <c:pt idx="84">
                  <c:v>2.4394250513000002</c:v>
                </c:pt>
                <c:pt idx="85">
                  <c:v>2.4394250513000002</c:v>
                </c:pt>
                <c:pt idx="86">
                  <c:v>2.4394250513000002</c:v>
                </c:pt>
                <c:pt idx="87">
                  <c:v>2.4476386037000002</c:v>
                </c:pt>
                <c:pt idx="88">
                  <c:v>2.4476386037000002</c:v>
                </c:pt>
                <c:pt idx="89">
                  <c:v>2.4476386037000002</c:v>
                </c:pt>
                <c:pt idx="90">
                  <c:v>2.4640657084000002</c:v>
                </c:pt>
                <c:pt idx="91">
                  <c:v>2.4640657084000002</c:v>
                </c:pt>
                <c:pt idx="92">
                  <c:v>2.4640657084000002</c:v>
                </c:pt>
                <c:pt idx="93">
                  <c:v>2.6694045174999999</c:v>
                </c:pt>
                <c:pt idx="94">
                  <c:v>2.6694045174999999</c:v>
                </c:pt>
                <c:pt idx="95">
                  <c:v>2.6694045174999999</c:v>
                </c:pt>
                <c:pt idx="96">
                  <c:v>2.8172484599999961</c:v>
                </c:pt>
                <c:pt idx="97">
                  <c:v>2.8172484599999961</c:v>
                </c:pt>
                <c:pt idx="98">
                  <c:v>2.8172484599999961</c:v>
                </c:pt>
                <c:pt idx="99">
                  <c:v>3.2553045858999998</c:v>
                </c:pt>
                <c:pt idx="100">
                  <c:v>3.2553045858999998</c:v>
                </c:pt>
                <c:pt idx="101">
                  <c:v>3.2553045858999998</c:v>
                </c:pt>
              </c:numCache>
            </c:numRef>
          </c:xVal>
          <c:yVal>
            <c:numRef>
              <c:f>SuppFigure2_OS!$B$1:$B$3500</c:f>
              <c:numCache>
                <c:formatCode>General</c:formatCode>
                <c:ptCount val="350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97142857140000005</c:v>
                </c:pt>
                <c:pt idx="4">
                  <c:v>0.97142857140000005</c:v>
                </c:pt>
                <c:pt idx="5">
                  <c:v>0.9428571429</c:v>
                </c:pt>
                <c:pt idx="6">
                  <c:v>0.9428571429</c:v>
                </c:pt>
                <c:pt idx="7">
                  <c:v>0.96285714290000002</c:v>
                </c:pt>
                <c:pt idx="8">
                  <c:v>0.9428571429</c:v>
                </c:pt>
                <c:pt idx="9">
                  <c:v>0.9428571429</c:v>
                </c:pt>
                <c:pt idx="10">
                  <c:v>0.96285714290000002</c:v>
                </c:pt>
                <c:pt idx="11">
                  <c:v>0.9428571429</c:v>
                </c:pt>
                <c:pt idx="12">
                  <c:v>0.9428571429</c:v>
                </c:pt>
                <c:pt idx="13">
                  <c:v>0.96285714290000002</c:v>
                </c:pt>
                <c:pt idx="14">
                  <c:v>0.9428571429</c:v>
                </c:pt>
                <c:pt idx="15">
                  <c:v>0.9428571429</c:v>
                </c:pt>
                <c:pt idx="16">
                  <c:v>0.9114285714</c:v>
                </c:pt>
                <c:pt idx="17">
                  <c:v>0.9114285714</c:v>
                </c:pt>
                <c:pt idx="18">
                  <c:v>0.93142857140000002</c:v>
                </c:pt>
                <c:pt idx="19">
                  <c:v>0.9114285714</c:v>
                </c:pt>
                <c:pt idx="20">
                  <c:v>0.9114285714</c:v>
                </c:pt>
                <c:pt idx="21">
                  <c:v>0.93142857140000002</c:v>
                </c:pt>
                <c:pt idx="22">
                  <c:v>0.9114285714</c:v>
                </c:pt>
                <c:pt idx="23">
                  <c:v>0.9114285714</c:v>
                </c:pt>
                <c:pt idx="24">
                  <c:v>0.93142857140000002</c:v>
                </c:pt>
                <c:pt idx="25">
                  <c:v>0.9114285714</c:v>
                </c:pt>
                <c:pt idx="26">
                  <c:v>0.9114285714</c:v>
                </c:pt>
                <c:pt idx="27">
                  <c:v>0.93142857140000002</c:v>
                </c:pt>
                <c:pt idx="28">
                  <c:v>0.9114285714</c:v>
                </c:pt>
                <c:pt idx="29">
                  <c:v>0.9114285714</c:v>
                </c:pt>
                <c:pt idx="30">
                  <c:v>0.93142857140000002</c:v>
                </c:pt>
                <c:pt idx="31">
                  <c:v>0.9114285714</c:v>
                </c:pt>
                <c:pt idx="32">
                  <c:v>0.9114285714</c:v>
                </c:pt>
                <c:pt idx="33">
                  <c:v>0.93142857140000002</c:v>
                </c:pt>
                <c:pt idx="34">
                  <c:v>0.9114285714</c:v>
                </c:pt>
                <c:pt idx="35">
                  <c:v>0.9114285714</c:v>
                </c:pt>
                <c:pt idx="36">
                  <c:v>0.93142857140000002</c:v>
                </c:pt>
                <c:pt idx="37">
                  <c:v>0.9114285714</c:v>
                </c:pt>
                <c:pt idx="38">
                  <c:v>0.9114285714</c:v>
                </c:pt>
                <c:pt idx="39">
                  <c:v>0.87</c:v>
                </c:pt>
                <c:pt idx="40">
                  <c:v>0.87</c:v>
                </c:pt>
                <c:pt idx="41">
                  <c:v>0.89</c:v>
                </c:pt>
                <c:pt idx="42">
                  <c:v>0.87</c:v>
                </c:pt>
                <c:pt idx="43">
                  <c:v>0.87</c:v>
                </c:pt>
                <c:pt idx="44">
                  <c:v>0.89</c:v>
                </c:pt>
                <c:pt idx="45">
                  <c:v>0.87</c:v>
                </c:pt>
                <c:pt idx="46">
                  <c:v>0.87</c:v>
                </c:pt>
                <c:pt idx="47">
                  <c:v>0.89</c:v>
                </c:pt>
                <c:pt idx="48">
                  <c:v>0.87</c:v>
                </c:pt>
                <c:pt idx="49">
                  <c:v>0.87</c:v>
                </c:pt>
                <c:pt idx="50">
                  <c:v>0.89</c:v>
                </c:pt>
                <c:pt idx="51">
                  <c:v>0.87</c:v>
                </c:pt>
                <c:pt idx="52">
                  <c:v>0.87</c:v>
                </c:pt>
                <c:pt idx="53">
                  <c:v>0.81882352940000003</c:v>
                </c:pt>
                <c:pt idx="54">
                  <c:v>0.81882352940000003</c:v>
                </c:pt>
                <c:pt idx="55">
                  <c:v>0.83882352940000005</c:v>
                </c:pt>
                <c:pt idx="56">
                  <c:v>0.81882352940000003</c:v>
                </c:pt>
                <c:pt idx="57">
                  <c:v>0.81882352940000003</c:v>
                </c:pt>
                <c:pt idx="58">
                  <c:v>0.83882352940000005</c:v>
                </c:pt>
                <c:pt idx="59">
                  <c:v>0.81882352940000003</c:v>
                </c:pt>
                <c:pt idx="60">
                  <c:v>0.81882352940000003</c:v>
                </c:pt>
                <c:pt idx="61">
                  <c:v>0.83882352940000005</c:v>
                </c:pt>
                <c:pt idx="62">
                  <c:v>0.81882352940000003</c:v>
                </c:pt>
                <c:pt idx="63">
                  <c:v>0.81882352940000003</c:v>
                </c:pt>
                <c:pt idx="64">
                  <c:v>0.83882352940000005</c:v>
                </c:pt>
                <c:pt idx="65">
                  <c:v>0.81882352940000003</c:v>
                </c:pt>
                <c:pt idx="66">
                  <c:v>0.81882352940000003</c:v>
                </c:pt>
                <c:pt idx="67">
                  <c:v>0.83882352940000005</c:v>
                </c:pt>
                <c:pt idx="68">
                  <c:v>0.81882352940000003</c:v>
                </c:pt>
                <c:pt idx="69">
                  <c:v>0.81882352940000003</c:v>
                </c:pt>
                <c:pt idx="70">
                  <c:v>0.83882352940000005</c:v>
                </c:pt>
                <c:pt idx="71">
                  <c:v>0.81882352940000003</c:v>
                </c:pt>
                <c:pt idx="72">
                  <c:v>0.81882352940000003</c:v>
                </c:pt>
                <c:pt idx="73">
                  <c:v>0.83882352940000005</c:v>
                </c:pt>
                <c:pt idx="74">
                  <c:v>0.81882352940000003</c:v>
                </c:pt>
                <c:pt idx="75">
                  <c:v>0.81882352940000003</c:v>
                </c:pt>
                <c:pt idx="76">
                  <c:v>0.83882352940000005</c:v>
                </c:pt>
                <c:pt idx="77">
                  <c:v>0.81882352940000003</c:v>
                </c:pt>
                <c:pt idx="78">
                  <c:v>0.81882352940000003</c:v>
                </c:pt>
                <c:pt idx="79">
                  <c:v>0.83882352940000005</c:v>
                </c:pt>
                <c:pt idx="80">
                  <c:v>0.81882352940000003</c:v>
                </c:pt>
                <c:pt idx="81">
                  <c:v>0.81882352940000003</c:v>
                </c:pt>
                <c:pt idx="82">
                  <c:v>0.83882352940000005</c:v>
                </c:pt>
                <c:pt idx="83">
                  <c:v>0.81882352940000003</c:v>
                </c:pt>
                <c:pt idx="84">
                  <c:v>0.81882352940000003</c:v>
                </c:pt>
                <c:pt idx="85">
                  <c:v>0.83882352940000005</c:v>
                </c:pt>
                <c:pt idx="86">
                  <c:v>0.81882352940000003</c:v>
                </c:pt>
                <c:pt idx="87">
                  <c:v>0.81882352940000003</c:v>
                </c:pt>
                <c:pt idx="88">
                  <c:v>0.83882352940000005</c:v>
                </c:pt>
                <c:pt idx="89">
                  <c:v>0.81882352940000003</c:v>
                </c:pt>
                <c:pt idx="90">
                  <c:v>0.81882352940000003</c:v>
                </c:pt>
                <c:pt idx="91">
                  <c:v>0.83882352940000005</c:v>
                </c:pt>
                <c:pt idx="92">
                  <c:v>0.81882352940000003</c:v>
                </c:pt>
                <c:pt idx="93">
                  <c:v>0.81882352940000003</c:v>
                </c:pt>
                <c:pt idx="94">
                  <c:v>0.83882352940000005</c:v>
                </c:pt>
                <c:pt idx="95">
                  <c:v>0.81882352940000003</c:v>
                </c:pt>
                <c:pt idx="96">
                  <c:v>0.81882352940000003</c:v>
                </c:pt>
                <c:pt idx="97">
                  <c:v>0.83882352940000005</c:v>
                </c:pt>
                <c:pt idx="98">
                  <c:v>0.81882352940000003</c:v>
                </c:pt>
                <c:pt idx="99">
                  <c:v>0.81882352940000003</c:v>
                </c:pt>
                <c:pt idx="100">
                  <c:v>0.83882352940000005</c:v>
                </c:pt>
                <c:pt idx="101">
                  <c:v>0.8188235294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02F-BA45-B62B-AEA3ECEBF7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5096336"/>
        <c:axId val="-1996704448"/>
      </c:scatterChart>
      <c:valAx>
        <c:axId val="-2125096336"/>
        <c:scaling>
          <c:orientation val="minMax"/>
          <c:max val="4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600"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-1996704448"/>
        <c:crosses val="autoZero"/>
        <c:crossBetween val="midCat"/>
        <c:majorUnit val="0.5"/>
      </c:valAx>
      <c:valAx>
        <c:axId val="-1996704448"/>
        <c:scaling>
          <c:orientation val="minMax"/>
          <c:max val="1.05"/>
          <c:min val="0"/>
        </c:scaling>
        <c:delete val="0"/>
        <c:axPos val="l"/>
        <c:numFmt formatCode="0.0_ " sourceLinked="0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600"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-2125096336"/>
        <c:crosses val="autoZero"/>
        <c:crossBetween val="midCat"/>
        <c:majorUnit val="0.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150" b="0" i="0" u="none" strike="noStrike" baseline="0">
          <a:solidFill>
            <a:srgbClr val="000000"/>
          </a:solidFill>
          <a:latin typeface="Arial" panose="020B0604020202020204" pitchFamily="34" charset="0"/>
          <a:ea typeface="ＭＳ Ｐゴシック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20436817472701"/>
          <c:y val="4.80481889551337E-2"/>
          <c:w val="0.81591263650545998"/>
          <c:h val="0.76877102328213998"/>
        </c:manualLayout>
      </c:layout>
      <c:scatterChart>
        <c:scatterStyle val="lineMarker"/>
        <c:varyColors val="0"/>
        <c:ser>
          <c:idx val="0"/>
          <c:order val="0"/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xVal>
            <c:numRef>
              <c:f>SuppFigure2_EFS!$A$1:$A$3500</c:f>
              <c:numCache>
                <c:formatCode>General</c:formatCode>
                <c:ptCount val="3500"/>
                <c:pt idx="0">
                  <c:v>0</c:v>
                </c:pt>
                <c:pt idx="1">
                  <c:v>0</c:v>
                </c:pt>
                <c:pt idx="2">
                  <c:v>0.3203285421</c:v>
                </c:pt>
                <c:pt idx="3">
                  <c:v>0.3203285421</c:v>
                </c:pt>
                <c:pt idx="4">
                  <c:v>0.58316221769999999</c:v>
                </c:pt>
                <c:pt idx="5">
                  <c:v>0.58316221769999999</c:v>
                </c:pt>
                <c:pt idx="6">
                  <c:v>0.61875427790000004</c:v>
                </c:pt>
                <c:pt idx="7">
                  <c:v>0.61875427790000004</c:v>
                </c:pt>
                <c:pt idx="8">
                  <c:v>0.643394935</c:v>
                </c:pt>
                <c:pt idx="9">
                  <c:v>0.643394935</c:v>
                </c:pt>
                <c:pt idx="10">
                  <c:v>0.7145790554</c:v>
                </c:pt>
                <c:pt idx="11">
                  <c:v>0.7145790554</c:v>
                </c:pt>
                <c:pt idx="12">
                  <c:v>0.74743326489999995</c:v>
                </c:pt>
                <c:pt idx="13">
                  <c:v>0.74743326489999995</c:v>
                </c:pt>
                <c:pt idx="14">
                  <c:v>0.75564681720000004</c:v>
                </c:pt>
                <c:pt idx="15">
                  <c:v>0.75564681720000004</c:v>
                </c:pt>
                <c:pt idx="16">
                  <c:v>0.75838466800000004</c:v>
                </c:pt>
                <c:pt idx="17">
                  <c:v>0.75838466800000004</c:v>
                </c:pt>
                <c:pt idx="18">
                  <c:v>0.80492813139999997</c:v>
                </c:pt>
                <c:pt idx="19">
                  <c:v>0.80492813139999997</c:v>
                </c:pt>
                <c:pt idx="20">
                  <c:v>0.84052019160000002</c:v>
                </c:pt>
                <c:pt idx="21">
                  <c:v>0.84052019160000002</c:v>
                </c:pt>
                <c:pt idx="22">
                  <c:v>0.87885010269999997</c:v>
                </c:pt>
                <c:pt idx="23">
                  <c:v>0.87885010269999997</c:v>
                </c:pt>
                <c:pt idx="24">
                  <c:v>0.92539356610000001</c:v>
                </c:pt>
                <c:pt idx="25">
                  <c:v>0.92539356610000001</c:v>
                </c:pt>
                <c:pt idx="26">
                  <c:v>0.95003422309999996</c:v>
                </c:pt>
                <c:pt idx="27">
                  <c:v>0.95003422309999996</c:v>
                </c:pt>
                <c:pt idx="28">
                  <c:v>1.0814510609000001</c:v>
                </c:pt>
                <c:pt idx="29">
                  <c:v>1.0814510609000001</c:v>
                </c:pt>
                <c:pt idx="30">
                  <c:v>1.1307323751</c:v>
                </c:pt>
                <c:pt idx="31">
                  <c:v>1.1307323751</c:v>
                </c:pt>
                <c:pt idx="32">
                  <c:v>1.1307323751</c:v>
                </c:pt>
                <c:pt idx="33">
                  <c:v>1.1745379877</c:v>
                </c:pt>
                <c:pt idx="34">
                  <c:v>1.1745379877</c:v>
                </c:pt>
                <c:pt idx="35">
                  <c:v>1.1745379877</c:v>
                </c:pt>
                <c:pt idx="36">
                  <c:v>1.2539356605</c:v>
                </c:pt>
                <c:pt idx="37">
                  <c:v>1.2539356605</c:v>
                </c:pt>
                <c:pt idx="38">
                  <c:v>1.2539356605</c:v>
                </c:pt>
                <c:pt idx="39">
                  <c:v>1.2621492129</c:v>
                </c:pt>
                <c:pt idx="40">
                  <c:v>1.2621492129</c:v>
                </c:pt>
                <c:pt idx="41">
                  <c:v>1.3196440793999999</c:v>
                </c:pt>
                <c:pt idx="42">
                  <c:v>1.3196440793999999</c:v>
                </c:pt>
                <c:pt idx="43">
                  <c:v>1.3196440793999999</c:v>
                </c:pt>
                <c:pt idx="44">
                  <c:v>1.3196440793999999</c:v>
                </c:pt>
                <c:pt idx="45">
                  <c:v>1.3196440793999999</c:v>
                </c:pt>
                <c:pt idx="46">
                  <c:v>1.3442847364999999</c:v>
                </c:pt>
                <c:pt idx="47">
                  <c:v>1.3442847364999999</c:v>
                </c:pt>
                <c:pt idx="48">
                  <c:v>1.3442847364999999</c:v>
                </c:pt>
                <c:pt idx="49">
                  <c:v>1.3470225872999999</c:v>
                </c:pt>
                <c:pt idx="50">
                  <c:v>1.3470225872999999</c:v>
                </c:pt>
                <c:pt idx="51">
                  <c:v>1.3826146475000001</c:v>
                </c:pt>
                <c:pt idx="52">
                  <c:v>1.3826146475000001</c:v>
                </c:pt>
                <c:pt idx="53">
                  <c:v>1.3826146475000001</c:v>
                </c:pt>
                <c:pt idx="54">
                  <c:v>1.4373716632</c:v>
                </c:pt>
                <c:pt idx="55">
                  <c:v>1.4373716632</c:v>
                </c:pt>
                <c:pt idx="56">
                  <c:v>1.4373716632</c:v>
                </c:pt>
                <c:pt idx="57">
                  <c:v>1.4647501710999999</c:v>
                </c:pt>
                <c:pt idx="58">
                  <c:v>1.4647501710999999</c:v>
                </c:pt>
                <c:pt idx="59">
                  <c:v>1.4647501710999999</c:v>
                </c:pt>
                <c:pt idx="60">
                  <c:v>1.5140314853000001</c:v>
                </c:pt>
                <c:pt idx="61">
                  <c:v>1.5140314853000001</c:v>
                </c:pt>
                <c:pt idx="62">
                  <c:v>1.5140314853000001</c:v>
                </c:pt>
                <c:pt idx="63">
                  <c:v>1.8836413415</c:v>
                </c:pt>
                <c:pt idx="64">
                  <c:v>1.8836413415</c:v>
                </c:pt>
                <c:pt idx="65">
                  <c:v>1.8836413415</c:v>
                </c:pt>
                <c:pt idx="66">
                  <c:v>1.9411362081000001</c:v>
                </c:pt>
                <c:pt idx="67">
                  <c:v>1.9411362081000001</c:v>
                </c:pt>
                <c:pt idx="68">
                  <c:v>1.9411362081000001</c:v>
                </c:pt>
                <c:pt idx="69">
                  <c:v>2.1848049281000002</c:v>
                </c:pt>
                <c:pt idx="70">
                  <c:v>2.1848049281000002</c:v>
                </c:pt>
                <c:pt idx="71">
                  <c:v>2.1848049281000002</c:v>
                </c:pt>
                <c:pt idx="72">
                  <c:v>2.2039698836000001</c:v>
                </c:pt>
                <c:pt idx="73">
                  <c:v>2.2039698836000001</c:v>
                </c:pt>
                <c:pt idx="74">
                  <c:v>2.2039698836000001</c:v>
                </c:pt>
                <c:pt idx="75">
                  <c:v>2.2751540041</c:v>
                </c:pt>
                <c:pt idx="76">
                  <c:v>2.2751540041</c:v>
                </c:pt>
                <c:pt idx="77">
                  <c:v>2.2751540041</c:v>
                </c:pt>
                <c:pt idx="78">
                  <c:v>2.4339493498000002</c:v>
                </c:pt>
                <c:pt idx="79">
                  <c:v>2.4339493498000002</c:v>
                </c:pt>
                <c:pt idx="80">
                  <c:v>2.6447638603999999</c:v>
                </c:pt>
                <c:pt idx="81">
                  <c:v>2.6447638603999999</c:v>
                </c:pt>
                <c:pt idx="82">
                  <c:v>2.6447638603999999</c:v>
                </c:pt>
                <c:pt idx="83">
                  <c:v>2.7980835044000001</c:v>
                </c:pt>
                <c:pt idx="84">
                  <c:v>2.7980835044000001</c:v>
                </c:pt>
                <c:pt idx="85">
                  <c:v>2.7980835044000001</c:v>
                </c:pt>
                <c:pt idx="86">
                  <c:v>3.0308008214000002</c:v>
                </c:pt>
                <c:pt idx="87">
                  <c:v>3.0308008214000002</c:v>
                </c:pt>
                <c:pt idx="88">
                  <c:v>3.0308008214000002</c:v>
                </c:pt>
              </c:numCache>
            </c:numRef>
          </c:xVal>
          <c:yVal>
            <c:numRef>
              <c:f>SuppFigure2_EFS!$B$1:$B$3500</c:f>
              <c:numCache>
                <c:formatCode>General</c:formatCode>
                <c:ptCount val="350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97142857140000005</c:v>
                </c:pt>
                <c:pt idx="4">
                  <c:v>0.97142857140000005</c:v>
                </c:pt>
                <c:pt idx="5">
                  <c:v>0.9428571429</c:v>
                </c:pt>
                <c:pt idx="6">
                  <c:v>0.9428571429</c:v>
                </c:pt>
                <c:pt idx="7">
                  <c:v>0.91428571430000005</c:v>
                </c:pt>
                <c:pt idx="8">
                  <c:v>0.91428571430000005</c:v>
                </c:pt>
                <c:pt idx="9">
                  <c:v>0.88571428569999999</c:v>
                </c:pt>
                <c:pt idx="10">
                  <c:v>0.88571428569999999</c:v>
                </c:pt>
                <c:pt idx="11">
                  <c:v>0.85714285710000004</c:v>
                </c:pt>
                <c:pt idx="12">
                  <c:v>0.85714285710000004</c:v>
                </c:pt>
                <c:pt idx="13">
                  <c:v>0.82857142859999999</c:v>
                </c:pt>
                <c:pt idx="14">
                  <c:v>0.82857142859999999</c:v>
                </c:pt>
                <c:pt idx="15">
                  <c:v>0.8</c:v>
                </c:pt>
                <c:pt idx="16">
                  <c:v>0.8</c:v>
                </c:pt>
                <c:pt idx="17">
                  <c:v>0.77142857139999998</c:v>
                </c:pt>
                <c:pt idx="18">
                  <c:v>0.77142857139999998</c:v>
                </c:pt>
                <c:pt idx="19">
                  <c:v>0.74285714290000004</c:v>
                </c:pt>
                <c:pt idx="20">
                  <c:v>0.74285714290000004</c:v>
                </c:pt>
                <c:pt idx="21">
                  <c:v>0.71428571429999999</c:v>
                </c:pt>
                <c:pt idx="22">
                  <c:v>0.71428571429999999</c:v>
                </c:pt>
                <c:pt idx="23">
                  <c:v>0.68571428570000004</c:v>
                </c:pt>
                <c:pt idx="24">
                  <c:v>0.68571428570000004</c:v>
                </c:pt>
                <c:pt idx="25">
                  <c:v>0.65714285709999998</c:v>
                </c:pt>
                <c:pt idx="26">
                  <c:v>0.65714285709999998</c:v>
                </c:pt>
                <c:pt idx="27">
                  <c:v>0.62857142860000004</c:v>
                </c:pt>
                <c:pt idx="28">
                  <c:v>0.62857142860000004</c:v>
                </c:pt>
                <c:pt idx="29">
                  <c:v>0.6</c:v>
                </c:pt>
                <c:pt idx="30">
                  <c:v>0.6</c:v>
                </c:pt>
                <c:pt idx="31">
                  <c:v>0.62</c:v>
                </c:pt>
                <c:pt idx="32">
                  <c:v>0.6</c:v>
                </c:pt>
                <c:pt idx="33">
                  <c:v>0.6</c:v>
                </c:pt>
                <c:pt idx="34">
                  <c:v>0.62</c:v>
                </c:pt>
                <c:pt idx="35">
                  <c:v>0.6</c:v>
                </c:pt>
                <c:pt idx="36">
                  <c:v>0.6</c:v>
                </c:pt>
                <c:pt idx="37">
                  <c:v>0.62</c:v>
                </c:pt>
                <c:pt idx="38">
                  <c:v>0.6</c:v>
                </c:pt>
                <c:pt idx="39">
                  <c:v>0.6</c:v>
                </c:pt>
                <c:pt idx="40">
                  <c:v>0.56666666669999999</c:v>
                </c:pt>
                <c:pt idx="41">
                  <c:v>0.56666666669999999</c:v>
                </c:pt>
                <c:pt idx="42">
                  <c:v>0.53333333329999999</c:v>
                </c:pt>
                <c:pt idx="43">
                  <c:v>0.53333333329999999</c:v>
                </c:pt>
                <c:pt idx="44">
                  <c:v>0.55333333330000001</c:v>
                </c:pt>
                <c:pt idx="45">
                  <c:v>0.53333333329999999</c:v>
                </c:pt>
                <c:pt idx="46">
                  <c:v>0.53333333329999999</c:v>
                </c:pt>
                <c:pt idx="47">
                  <c:v>0.55333333330000001</c:v>
                </c:pt>
                <c:pt idx="48">
                  <c:v>0.53333333329999999</c:v>
                </c:pt>
                <c:pt idx="49">
                  <c:v>0.53333333329999999</c:v>
                </c:pt>
                <c:pt idx="50">
                  <c:v>0.49523809520000001</c:v>
                </c:pt>
                <c:pt idx="51">
                  <c:v>0.49523809520000001</c:v>
                </c:pt>
                <c:pt idx="52">
                  <c:v>0.51523809519999997</c:v>
                </c:pt>
                <c:pt idx="53">
                  <c:v>0.49523809520000001</c:v>
                </c:pt>
                <c:pt idx="54">
                  <c:v>0.49523809520000001</c:v>
                </c:pt>
                <c:pt idx="55">
                  <c:v>0.51523809519999997</c:v>
                </c:pt>
                <c:pt idx="56">
                  <c:v>0.49523809520000001</c:v>
                </c:pt>
                <c:pt idx="57">
                  <c:v>0.49523809520000001</c:v>
                </c:pt>
                <c:pt idx="58">
                  <c:v>0.51523809519999997</c:v>
                </c:pt>
                <c:pt idx="59">
                  <c:v>0.49523809520000001</c:v>
                </c:pt>
                <c:pt idx="60">
                  <c:v>0.49523809520000001</c:v>
                </c:pt>
                <c:pt idx="61">
                  <c:v>0.51523809519999997</c:v>
                </c:pt>
                <c:pt idx="62">
                  <c:v>0.49523809520000001</c:v>
                </c:pt>
                <c:pt idx="63">
                  <c:v>0.49523809520000001</c:v>
                </c:pt>
                <c:pt idx="64">
                  <c:v>0.51523809519999997</c:v>
                </c:pt>
                <c:pt idx="65">
                  <c:v>0.49523809520000001</c:v>
                </c:pt>
                <c:pt idx="66">
                  <c:v>0.49523809520000001</c:v>
                </c:pt>
                <c:pt idx="67">
                  <c:v>0.51523809519999997</c:v>
                </c:pt>
                <c:pt idx="68">
                  <c:v>0.49523809520000001</c:v>
                </c:pt>
                <c:pt idx="69">
                  <c:v>0.49523809520000001</c:v>
                </c:pt>
                <c:pt idx="70">
                  <c:v>0.51523809519999997</c:v>
                </c:pt>
                <c:pt idx="71">
                  <c:v>0.49523809520000001</c:v>
                </c:pt>
                <c:pt idx="72">
                  <c:v>0.49523809520000001</c:v>
                </c:pt>
                <c:pt idx="73">
                  <c:v>0.51523809519999997</c:v>
                </c:pt>
                <c:pt idx="74">
                  <c:v>0.49523809520000001</c:v>
                </c:pt>
                <c:pt idx="75">
                  <c:v>0.49523809520000001</c:v>
                </c:pt>
                <c:pt idx="76">
                  <c:v>0.51523809519999997</c:v>
                </c:pt>
                <c:pt idx="77">
                  <c:v>0.49523809520000001</c:v>
                </c:pt>
                <c:pt idx="78">
                  <c:v>0.49523809520000001</c:v>
                </c:pt>
                <c:pt idx="79">
                  <c:v>0.37142857140000002</c:v>
                </c:pt>
                <c:pt idx="80">
                  <c:v>0.37142857140000002</c:v>
                </c:pt>
                <c:pt idx="81">
                  <c:v>0.39142857139999998</c:v>
                </c:pt>
                <c:pt idx="82">
                  <c:v>0.37142857140000002</c:v>
                </c:pt>
                <c:pt idx="83">
                  <c:v>0.37142857140000002</c:v>
                </c:pt>
                <c:pt idx="84">
                  <c:v>0.39142857139999998</c:v>
                </c:pt>
                <c:pt idx="85">
                  <c:v>0.37142857140000002</c:v>
                </c:pt>
                <c:pt idx="86">
                  <c:v>0.37142857140000002</c:v>
                </c:pt>
                <c:pt idx="87">
                  <c:v>0.39142857139999998</c:v>
                </c:pt>
                <c:pt idx="88">
                  <c:v>0.3714285714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8DC-CD44-B01F-466D5D210C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25803008"/>
        <c:axId val="1778349136"/>
      </c:scatterChart>
      <c:valAx>
        <c:axId val="-2025803008"/>
        <c:scaling>
          <c:orientation val="minMax"/>
          <c:max val="4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600"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1778349136"/>
        <c:crosses val="autoZero"/>
        <c:crossBetween val="midCat"/>
        <c:majorUnit val="0.5"/>
      </c:valAx>
      <c:valAx>
        <c:axId val="1778349136"/>
        <c:scaling>
          <c:orientation val="minMax"/>
          <c:max val="1.05"/>
          <c:min val="0"/>
        </c:scaling>
        <c:delete val="0"/>
        <c:axPos val="l"/>
        <c:numFmt formatCode="0.0_ " sourceLinked="0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600"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-2025803008"/>
        <c:crosses val="autoZero"/>
        <c:crossBetween val="midCat"/>
        <c:majorUnit val="0.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150" b="0" i="0" u="none" strike="noStrike" baseline="0">
          <a:solidFill>
            <a:srgbClr val="000000"/>
          </a:solidFill>
          <a:latin typeface="Arial" panose="020B0604020202020204" pitchFamily="34" charset="0"/>
          <a:ea typeface="ＭＳ Ｐゴシック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20436817472701"/>
          <c:y val="4.80481889551337E-2"/>
          <c:w val="0.81591263650545998"/>
          <c:h val="0.76877102328213998"/>
        </c:manualLayout>
      </c:layout>
      <c:scatterChart>
        <c:scatterStyle val="lineMarker"/>
        <c:varyColors val="0"/>
        <c:ser>
          <c:idx val="0"/>
          <c:order val="0"/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xVal>
            <c:numRef>
              <c:f>SuppFigure2_TTLP!$A$1:$A$3500</c:f>
              <c:numCache>
                <c:formatCode>General</c:formatCode>
                <c:ptCount val="3500"/>
                <c:pt idx="0">
                  <c:v>0</c:v>
                </c:pt>
                <c:pt idx="1">
                  <c:v>0</c:v>
                </c:pt>
                <c:pt idx="2">
                  <c:v>0.3203285421</c:v>
                </c:pt>
                <c:pt idx="3">
                  <c:v>0.3203285421</c:v>
                </c:pt>
                <c:pt idx="4">
                  <c:v>0.58316221769999999</c:v>
                </c:pt>
                <c:pt idx="5">
                  <c:v>0.58316221769999999</c:v>
                </c:pt>
                <c:pt idx="6">
                  <c:v>0.61875427790000004</c:v>
                </c:pt>
                <c:pt idx="7">
                  <c:v>0.61875427790000004</c:v>
                </c:pt>
                <c:pt idx="8">
                  <c:v>0.643394935</c:v>
                </c:pt>
                <c:pt idx="9">
                  <c:v>0.643394935</c:v>
                </c:pt>
                <c:pt idx="10">
                  <c:v>0.7145790554</c:v>
                </c:pt>
                <c:pt idx="11">
                  <c:v>0.7145790554</c:v>
                </c:pt>
                <c:pt idx="12">
                  <c:v>0.74743326489999995</c:v>
                </c:pt>
                <c:pt idx="13">
                  <c:v>0.74743326489999995</c:v>
                </c:pt>
                <c:pt idx="14">
                  <c:v>0.75564681720000004</c:v>
                </c:pt>
                <c:pt idx="15">
                  <c:v>0.75564681720000004</c:v>
                </c:pt>
                <c:pt idx="16">
                  <c:v>0.75838466800000004</c:v>
                </c:pt>
                <c:pt idx="17">
                  <c:v>0.75838466800000004</c:v>
                </c:pt>
                <c:pt idx="18">
                  <c:v>0.80492813139999997</c:v>
                </c:pt>
                <c:pt idx="19">
                  <c:v>0.80492813139999997</c:v>
                </c:pt>
                <c:pt idx="20">
                  <c:v>0.84052019160000002</c:v>
                </c:pt>
                <c:pt idx="21">
                  <c:v>0.84052019160000002</c:v>
                </c:pt>
                <c:pt idx="22">
                  <c:v>0.87885010269999997</c:v>
                </c:pt>
                <c:pt idx="23">
                  <c:v>0.87885010269999997</c:v>
                </c:pt>
                <c:pt idx="24">
                  <c:v>0.92539356610000001</c:v>
                </c:pt>
                <c:pt idx="25">
                  <c:v>0.92539356610000001</c:v>
                </c:pt>
                <c:pt idx="26">
                  <c:v>0.95003422309999996</c:v>
                </c:pt>
                <c:pt idx="27">
                  <c:v>0.95003422309999996</c:v>
                </c:pt>
                <c:pt idx="28">
                  <c:v>1.0814510609000001</c:v>
                </c:pt>
                <c:pt idx="29">
                  <c:v>1.0814510609000001</c:v>
                </c:pt>
                <c:pt idx="30">
                  <c:v>1.1307323751</c:v>
                </c:pt>
                <c:pt idx="31">
                  <c:v>1.1307323751</c:v>
                </c:pt>
                <c:pt idx="32">
                  <c:v>1.1307323751</c:v>
                </c:pt>
                <c:pt idx="33">
                  <c:v>1.1745379877</c:v>
                </c:pt>
                <c:pt idx="34">
                  <c:v>1.1745379877</c:v>
                </c:pt>
                <c:pt idx="35">
                  <c:v>1.1745379877</c:v>
                </c:pt>
                <c:pt idx="36">
                  <c:v>1.2539356605</c:v>
                </c:pt>
                <c:pt idx="37">
                  <c:v>1.2539356605</c:v>
                </c:pt>
                <c:pt idx="38">
                  <c:v>1.2539356605</c:v>
                </c:pt>
                <c:pt idx="39">
                  <c:v>1.2621492129</c:v>
                </c:pt>
                <c:pt idx="40">
                  <c:v>1.2621492129</c:v>
                </c:pt>
                <c:pt idx="41">
                  <c:v>1.3196440793999999</c:v>
                </c:pt>
                <c:pt idx="42">
                  <c:v>1.3196440793999999</c:v>
                </c:pt>
                <c:pt idx="43">
                  <c:v>1.3196440793999999</c:v>
                </c:pt>
                <c:pt idx="44">
                  <c:v>1.3196440793999999</c:v>
                </c:pt>
                <c:pt idx="45">
                  <c:v>1.3196440793999999</c:v>
                </c:pt>
                <c:pt idx="46">
                  <c:v>1.3442847364999999</c:v>
                </c:pt>
                <c:pt idx="47">
                  <c:v>1.3442847364999999</c:v>
                </c:pt>
                <c:pt idx="48">
                  <c:v>1.3442847364999999</c:v>
                </c:pt>
                <c:pt idx="49">
                  <c:v>1.3470225872999999</c:v>
                </c:pt>
                <c:pt idx="50">
                  <c:v>1.3470225872999999</c:v>
                </c:pt>
                <c:pt idx="51">
                  <c:v>1.3826146475000001</c:v>
                </c:pt>
                <c:pt idx="52">
                  <c:v>1.3826146475000001</c:v>
                </c:pt>
                <c:pt idx="53">
                  <c:v>1.3826146475000001</c:v>
                </c:pt>
                <c:pt idx="54">
                  <c:v>1.4373716632</c:v>
                </c:pt>
                <c:pt idx="55">
                  <c:v>1.4373716632</c:v>
                </c:pt>
                <c:pt idx="56">
                  <c:v>1.4373716632</c:v>
                </c:pt>
                <c:pt idx="57">
                  <c:v>1.4647501710999999</c:v>
                </c:pt>
                <c:pt idx="58">
                  <c:v>1.4647501710999999</c:v>
                </c:pt>
                <c:pt idx="59">
                  <c:v>1.4647501710999999</c:v>
                </c:pt>
                <c:pt idx="60">
                  <c:v>1.5140314853000001</c:v>
                </c:pt>
                <c:pt idx="61">
                  <c:v>1.5140314853000001</c:v>
                </c:pt>
                <c:pt idx="62">
                  <c:v>1.5140314853000001</c:v>
                </c:pt>
                <c:pt idx="63">
                  <c:v>1.8836413415</c:v>
                </c:pt>
                <c:pt idx="64">
                  <c:v>1.8836413415</c:v>
                </c:pt>
                <c:pt idx="65">
                  <c:v>1.8836413415</c:v>
                </c:pt>
                <c:pt idx="66">
                  <c:v>1.9411362081000001</c:v>
                </c:pt>
                <c:pt idx="67">
                  <c:v>1.9411362081000001</c:v>
                </c:pt>
                <c:pt idx="68">
                  <c:v>1.9411362081000001</c:v>
                </c:pt>
                <c:pt idx="69">
                  <c:v>2.1848049281000002</c:v>
                </c:pt>
                <c:pt idx="70">
                  <c:v>2.1848049281000002</c:v>
                </c:pt>
                <c:pt idx="71">
                  <c:v>2.1848049281000002</c:v>
                </c:pt>
                <c:pt idx="72">
                  <c:v>2.2039698836000001</c:v>
                </c:pt>
                <c:pt idx="73">
                  <c:v>2.2039698836000001</c:v>
                </c:pt>
                <c:pt idx="74">
                  <c:v>2.2039698836000001</c:v>
                </c:pt>
                <c:pt idx="75">
                  <c:v>2.2751540041</c:v>
                </c:pt>
                <c:pt idx="76">
                  <c:v>2.2751540041</c:v>
                </c:pt>
                <c:pt idx="77">
                  <c:v>2.2751540041</c:v>
                </c:pt>
                <c:pt idx="78">
                  <c:v>2.4339493498000002</c:v>
                </c:pt>
                <c:pt idx="79">
                  <c:v>2.4339493498000002</c:v>
                </c:pt>
                <c:pt idx="80">
                  <c:v>2.6447638603999999</c:v>
                </c:pt>
                <c:pt idx="81">
                  <c:v>2.6447638603999999</c:v>
                </c:pt>
                <c:pt idx="82">
                  <c:v>2.6447638603999999</c:v>
                </c:pt>
                <c:pt idx="83">
                  <c:v>2.7980835044000001</c:v>
                </c:pt>
                <c:pt idx="84">
                  <c:v>2.7980835044000001</c:v>
                </c:pt>
                <c:pt idx="85">
                  <c:v>2.7980835044000001</c:v>
                </c:pt>
                <c:pt idx="86">
                  <c:v>3.0308008214000002</c:v>
                </c:pt>
                <c:pt idx="87">
                  <c:v>3.0308008214000002</c:v>
                </c:pt>
                <c:pt idx="88">
                  <c:v>3.0308008214000002</c:v>
                </c:pt>
              </c:numCache>
            </c:numRef>
          </c:xVal>
          <c:yVal>
            <c:numRef>
              <c:f>SuppFigure2_TTLP!$B$1:$B$3500</c:f>
              <c:numCache>
                <c:formatCode>General</c:formatCode>
                <c:ptCount val="350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.85714286E-2</c:v>
                </c:pt>
                <c:pt idx="4">
                  <c:v>2.85714286E-2</c:v>
                </c:pt>
                <c:pt idx="5">
                  <c:v>5.71428571E-2</c:v>
                </c:pt>
                <c:pt idx="6">
                  <c:v>5.71428571E-2</c:v>
                </c:pt>
                <c:pt idx="7">
                  <c:v>8.5714285700000004E-2</c:v>
                </c:pt>
                <c:pt idx="8">
                  <c:v>8.5714285700000004E-2</c:v>
                </c:pt>
                <c:pt idx="9">
                  <c:v>0.11428571429999999</c:v>
                </c:pt>
                <c:pt idx="10">
                  <c:v>0.11428571429999999</c:v>
                </c:pt>
                <c:pt idx="11">
                  <c:v>0.14285714290000001</c:v>
                </c:pt>
                <c:pt idx="12">
                  <c:v>0.14285714290000001</c:v>
                </c:pt>
                <c:pt idx="13">
                  <c:v>0.17142857140000001</c:v>
                </c:pt>
                <c:pt idx="14">
                  <c:v>0.17142857140000001</c:v>
                </c:pt>
                <c:pt idx="15">
                  <c:v>0.17142857140000001</c:v>
                </c:pt>
                <c:pt idx="16">
                  <c:v>0.17142857140000001</c:v>
                </c:pt>
                <c:pt idx="17">
                  <c:v>0.17142857140000001</c:v>
                </c:pt>
                <c:pt idx="18">
                  <c:v>0.17142857140000001</c:v>
                </c:pt>
                <c:pt idx="19">
                  <c:v>0.2</c:v>
                </c:pt>
                <c:pt idx="20">
                  <c:v>0.2</c:v>
                </c:pt>
                <c:pt idx="21">
                  <c:v>0.22857142859999999</c:v>
                </c:pt>
                <c:pt idx="22">
                  <c:v>0.22857142859999999</c:v>
                </c:pt>
                <c:pt idx="23">
                  <c:v>0.25714285710000001</c:v>
                </c:pt>
                <c:pt idx="24">
                  <c:v>0.25714285710000001</c:v>
                </c:pt>
                <c:pt idx="25">
                  <c:v>0.28571428570000001</c:v>
                </c:pt>
                <c:pt idx="26">
                  <c:v>0.28571428570000001</c:v>
                </c:pt>
                <c:pt idx="27">
                  <c:v>0.31428571430000002</c:v>
                </c:pt>
                <c:pt idx="28">
                  <c:v>0.31428571430000002</c:v>
                </c:pt>
                <c:pt idx="29">
                  <c:v>0.34285714290000002</c:v>
                </c:pt>
                <c:pt idx="30">
                  <c:v>0.34285714290000002</c:v>
                </c:pt>
                <c:pt idx="31">
                  <c:v>0.36285714289999998</c:v>
                </c:pt>
                <c:pt idx="32">
                  <c:v>0.34285714290000002</c:v>
                </c:pt>
                <c:pt idx="33">
                  <c:v>0.34285714290000002</c:v>
                </c:pt>
                <c:pt idx="34">
                  <c:v>0.36285714289999998</c:v>
                </c:pt>
                <c:pt idx="35">
                  <c:v>0.34285714290000002</c:v>
                </c:pt>
                <c:pt idx="36">
                  <c:v>0.34285714290000002</c:v>
                </c:pt>
                <c:pt idx="37">
                  <c:v>0.36285714289999998</c:v>
                </c:pt>
                <c:pt idx="38">
                  <c:v>0.34285714290000002</c:v>
                </c:pt>
                <c:pt idx="39">
                  <c:v>0.34285714290000002</c:v>
                </c:pt>
                <c:pt idx="40">
                  <c:v>0.34285714290000002</c:v>
                </c:pt>
                <c:pt idx="41">
                  <c:v>0.34285714290000002</c:v>
                </c:pt>
                <c:pt idx="42">
                  <c:v>0.37619047620000001</c:v>
                </c:pt>
                <c:pt idx="43">
                  <c:v>0.37619047620000001</c:v>
                </c:pt>
                <c:pt idx="44">
                  <c:v>0.39619047619999997</c:v>
                </c:pt>
                <c:pt idx="45">
                  <c:v>0.37619047620000001</c:v>
                </c:pt>
                <c:pt idx="46">
                  <c:v>0.37619047620000001</c:v>
                </c:pt>
                <c:pt idx="47">
                  <c:v>0.39619047619999997</c:v>
                </c:pt>
                <c:pt idx="48">
                  <c:v>0.37619047620000001</c:v>
                </c:pt>
                <c:pt idx="49">
                  <c:v>0.37619047620000001</c:v>
                </c:pt>
                <c:pt idx="50">
                  <c:v>0.4142857143</c:v>
                </c:pt>
                <c:pt idx="51">
                  <c:v>0.4142857143</c:v>
                </c:pt>
                <c:pt idx="52">
                  <c:v>0.43428571430000001</c:v>
                </c:pt>
                <c:pt idx="53">
                  <c:v>0.4142857143</c:v>
                </c:pt>
                <c:pt idx="54">
                  <c:v>0.4142857143</c:v>
                </c:pt>
                <c:pt idx="55">
                  <c:v>0.43428571430000001</c:v>
                </c:pt>
                <c:pt idx="56">
                  <c:v>0.4142857143</c:v>
                </c:pt>
                <c:pt idx="57">
                  <c:v>0.4142857143</c:v>
                </c:pt>
                <c:pt idx="58">
                  <c:v>0.43428571430000001</c:v>
                </c:pt>
                <c:pt idx="59">
                  <c:v>0.4142857143</c:v>
                </c:pt>
                <c:pt idx="60">
                  <c:v>0.4142857143</c:v>
                </c:pt>
                <c:pt idx="61">
                  <c:v>0.43428571430000001</c:v>
                </c:pt>
                <c:pt idx="62">
                  <c:v>0.4142857143</c:v>
                </c:pt>
                <c:pt idx="63">
                  <c:v>0.4142857143</c:v>
                </c:pt>
                <c:pt idx="64">
                  <c:v>0.43428571430000001</c:v>
                </c:pt>
                <c:pt idx="65">
                  <c:v>0.4142857143</c:v>
                </c:pt>
                <c:pt idx="66">
                  <c:v>0.4142857143</c:v>
                </c:pt>
                <c:pt idx="67">
                  <c:v>0.43428571430000001</c:v>
                </c:pt>
                <c:pt idx="68">
                  <c:v>0.4142857143</c:v>
                </c:pt>
                <c:pt idx="69">
                  <c:v>0.4142857143</c:v>
                </c:pt>
                <c:pt idx="70">
                  <c:v>0.43428571430000001</c:v>
                </c:pt>
                <c:pt idx="71">
                  <c:v>0.4142857143</c:v>
                </c:pt>
                <c:pt idx="72">
                  <c:v>0.4142857143</c:v>
                </c:pt>
                <c:pt idx="73">
                  <c:v>0.43428571430000001</c:v>
                </c:pt>
                <c:pt idx="74">
                  <c:v>0.4142857143</c:v>
                </c:pt>
                <c:pt idx="75">
                  <c:v>0.4142857143</c:v>
                </c:pt>
                <c:pt idx="76">
                  <c:v>0.43428571430000001</c:v>
                </c:pt>
                <c:pt idx="77">
                  <c:v>0.4142857143</c:v>
                </c:pt>
                <c:pt idx="78">
                  <c:v>0.4142857143</c:v>
                </c:pt>
                <c:pt idx="79">
                  <c:v>0.53809523810000004</c:v>
                </c:pt>
                <c:pt idx="80">
                  <c:v>0.53809523810000004</c:v>
                </c:pt>
                <c:pt idx="81">
                  <c:v>0.55809523809999995</c:v>
                </c:pt>
                <c:pt idx="82">
                  <c:v>0.53809523810000004</c:v>
                </c:pt>
                <c:pt idx="83">
                  <c:v>0.53809523810000004</c:v>
                </c:pt>
                <c:pt idx="84">
                  <c:v>0.55809523809999995</c:v>
                </c:pt>
                <c:pt idx="85">
                  <c:v>0.53809523810000004</c:v>
                </c:pt>
                <c:pt idx="86">
                  <c:v>0.53809523810000004</c:v>
                </c:pt>
                <c:pt idx="87">
                  <c:v>0.55809523809999995</c:v>
                </c:pt>
                <c:pt idx="88">
                  <c:v>0.5380952381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75D-B842-B955-547E61383A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8219856"/>
        <c:axId val="-1997527840"/>
      </c:scatterChart>
      <c:valAx>
        <c:axId val="1778219856"/>
        <c:scaling>
          <c:orientation val="minMax"/>
          <c:max val="4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600"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-1997527840"/>
        <c:crosses val="autoZero"/>
        <c:crossBetween val="midCat"/>
        <c:majorUnit val="0.5"/>
      </c:valAx>
      <c:valAx>
        <c:axId val="-1997527840"/>
        <c:scaling>
          <c:orientation val="minMax"/>
          <c:max val="1.05"/>
          <c:min val="0"/>
        </c:scaling>
        <c:delete val="0"/>
        <c:axPos val="l"/>
        <c:numFmt formatCode="0.0_ " sourceLinked="0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600"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1778219856"/>
        <c:crosses val="autoZero"/>
        <c:crossBetween val="midCat"/>
        <c:majorUnit val="0.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150" b="0" i="0" u="none" strike="noStrike" baseline="0">
          <a:solidFill>
            <a:srgbClr val="000000"/>
          </a:solidFill>
          <a:latin typeface="Arial" panose="020B0604020202020204" pitchFamily="34" charset="0"/>
          <a:ea typeface="ＭＳ Ｐゴシック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20436817472701"/>
          <c:y val="4.80481889551337E-2"/>
          <c:w val="0.81591263650545998"/>
          <c:h val="0.76877102328213998"/>
        </c:manualLayout>
      </c:layout>
      <c:scatterChart>
        <c:scatterStyle val="lineMarker"/>
        <c:varyColors val="0"/>
        <c:ser>
          <c:idx val="0"/>
          <c:order val="0"/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xVal>
            <c:numRef>
              <c:f>SuppFigure2_TTDM!$A$1:$A$3500</c:f>
              <c:numCache>
                <c:formatCode>General</c:formatCode>
                <c:ptCount val="3500"/>
                <c:pt idx="0">
                  <c:v>0</c:v>
                </c:pt>
                <c:pt idx="1">
                  <c:v>0</c:v>
                </c:pt>
                <c:pt idx="2">
                  <c:v>0.3203285421</c:v>
                </c:pt>
                <c:pt idx="3">
                  <c:v>0.3203285421</c:v>
                </c:pt>
                <c:pt idx="4">
                  <c:v>0.58316221769999999</c:v>
                </c:pt>
                <c:pt idx="5">
                  <c:v>0.58316221769999999</c:v>
                </c:pt>
                <c:pt idx="6">
                  <c:v>0.61875427790000004</c:v>
                </c:pt>
                <c:pt idx="7">
                  <c:v>0.61875427790000004</c:v>
                </c:pt>
                <c:pt idx="8">
                  <c:v>0.643394935</c:v>
                </c:pt>
                <c:pt idx="9">
                  <c:v>0.643394935</c:v>
                </c:pt>
                <c:pt idx="10">
                  <c:v>0.7145790554</c:v>
                </c:pt>
                <c:pt idx="11">
                  <c:v>0.7145790554</c:v>
                </c:pt>
                <c:pt idx="12">
                  <c:v>0.74743326489999995</c:v>
                </c:pt>
                <c:pt idx="13">
                  <c:v>0.74743326489999995</c:v>
                </c:pt>
                <c:pt idx="14">
                  <c:v>0.75564681720000004</c:v>
                </c:pt>
                <c:pt idx="15">
                  <c:v>0.75564681720000004</c:v>
                </c:pt>
                <c:pt idx="16">
                  <c:v>0.75838466800000004</c:v>
                </c:pt>
                <c:pt idx="17">
                  <c:v>0.75838466800000004</c:v>
                </c:pt>
                <c:pt idx="18">
                  <c:v>0.80492813139999997</c:v>
                </c:pt>
                <c:pt idx="19">
                  <c:v>0.80492813139999997</c:v>
                </c:pt>
                <c:pt idx="20">
                  <c:v>0.84052019160000002</c:v>
                </c:pt>
                <c:pt idx="21">
                  <c:v>0.84052019160000002</c:v>
                </c:pt>
                <c:pt idx="22">
                  <c:v>0.87885010269999997</c:v>
                </c:pt>
                <c:pt idx="23">
                  <c:v>0.87885010269999997</c:v>
                </c:pt>
                <c:pt idx="24">
                  <c:v>0.92539356610000001</c:v>
                </c:pt>
                <c:pt idx="25">
                  <c:v>0.92539356610000001</c:v>
                </c:pt>
                <c:pt idx="26">
                  <c:v>0.95003422309999996</c:v>
                </c:pt>
                <c:pt idx="27">
                  <c:v>0.95003422309999996</c:v>
                </c:pt>
                <c:pt idx="28">
                  <c:v>1.0814510609000001</c:v>
                </c:pt>
                <c:pt idx="29">
                  <c:v>1.0814510609000001</c:v>
                </c:pt>
                <c:pt idx="30">
                  <c:v>1.1307323751</c:v>
                </c:pt>
                <c:pt idx="31">
                  <c:v>1.1307323751</c:v>
                </c:pt>
                <c:pt idx="32">
                  <c:v>1.1307323751</c:v>
                </c:pt>
                <c:pt idx="33">
                  <c:v>1.1745379877</c:v>
                </c:pt>
                <c:pt idx="34">
                  <c:v>1.1745379877</c:v>
                </c:pt>
                <c:pt idx="35">
                  <c:v>1.1745379877</c:v>
                </c:pt>
                <c:pt idx="36">
                  <c:v>1.2539356605</c:v>
                </c:pt>
                <c:pt idx="37">
                  <c:v>1.2539356605</c:v>
                </c:pt>
                <c:pt idx="38">
                  <c:v>1.2539356605</c:v>
                </c:pt>
                <c:pt idx="39">
                  <c:v>1.2621492129</c:v>
                </c:pt>
                <c:pt idx="40">
                  <c:v>1.2621492129</c:v>
                </c:pt>
                <c:pt idx="41">
                  <c:v>1.3196440793999999</c:v>
                </c:pt>
                <c:pt idx="42">
                  <c:v>1.3196440793999999</c:v>
                </c:pt>
                <c:pt idx="43">
                  <c:v>1.3196440793999999</c:v>
                </c:pt>
                <c:pt idx="44">
                  <c:v>1.3196440793999999</c:v>
                </c:pt>
                <c:pt idx="45">
                  <c:v>1.3196440793999999</c:v>
                </c:pt>
                <c:pt idx="46">
                  <c:v>1.3442847364999999</c:v>
                </c:pt>
                <c:pt idx="47">
                  <c:v>1.3442847364999999</c:v>
                </c:pt>
                <c:pt idx="48">
                  <c:v>1.3442847364999999</c:v>
                </c:pt>
                <c:pt idx="49">
                  <c:v>1.3470225872999999</c:v>
                </c:pt>
                <c:pt idx="50">
                  <c:v>1.3470225872999999</c:v>
                </c:pt>
                <c:pt idx="51">
                  <c:v>1.3826146475000001</c:v>
                </c:pt>
                <c:pt idx="52">
                  <c:v>1.3826146475000001</c:v>
                </c:pt>
                <c:pt idx="53">
                  <c:v>1.3826146475000001</c:v>
                </c:pt>
                <c:pt idx="54">
                  <c:v>1.4373716632</c:v>
                </c:pt>
                <c:pt idx="55">
                  <c:v>1.4373716632</c:v>
                </c:pt>
                <c:pt idx="56">
                  <c:v>1.4373716632</c:v>
                </c:pt>
                <c:pt idx="57">
                  <c:v>1.4647501710999999</c:v>
                </c:pt>
                <c:pt idx="58">
                  <c:v>1.4647501710999999</c:v>
                </c:pt>
                <c:pt idx="59">
                  <c:v>1.4647501710999999</c:v>
                </c:pt>
                <c:pt idx="60">
                  <c:v>1.5140314853000001</c:v>
                </c:pt>
                <c:pt idx="61">
                  <c:v>1.5140314853000001</c:v>
                </c:pt>
                <c:pt idx="62">
                  <c:v>1.5140314853000001</c:v>
                </c:pt>
                <c:pt idx="63">
                  <c:v>1.8836413415</c:v>
                </c:pt>
                <c:pt idx="64">
                  <c:v>1.8836413415</c:v>
                </c:pt>
                <c:pt idx="65">
                  <c:v>1.8836413415</c:v>
                </c:pt>
                <c:pt idx="66">
                  <c:v>1.9411362081000001</c:v>
                </c:pt>
                <c:pt idx="67">
                  <c:v>1.9411362081000001</c:v>
                </c:pt>
                <c:pt idx="68">
                  <c:v>1.9411362081000001</c:v>
                </c:pt>
                <c:pt idx="69">
                  <c:v>2.1848049281000002</c:v>
                </c:pt>
                <c:pt idx="70">
                  <c:v>2.1848049281000002</c:v>
                </c:pt>
                <c:pt idx="71">
                  <c:v>2.1848049281000002</c:v>
                </c:pt>
                <c:pt idx="72">
                  <c:v>2.2039698836000001</c:v>
                </c:pt>
                <c:pt idx="73">
                  <c:v>2.2039698836000001</c:v>
                </c:pt>
                <c:pt idx="74">
                  <c:v>2.2039698836000001</c:v>
                </c:pt>
                <c:pt idx="75">
                  <c:v>2.2751540041</c:v>
                </c:pt>
                <c:pt idx="76">
                  <c:v>2.2751540041</c:v>
                </c:pt>
                <c:pt idx="77">
                  <c:v>2.2751540041</c:v>
                </c:pt>
                <c:pt idx="78">
                  <c:v>2.4339493498000002</c:v>
                </c:pt>
                <c:pt idx="79">
                  <c:v>2.4339493498000002</c:v>
                </c:pt>
                <c:pt idx="80">
                  <c:v>2.6447638603999999</c:v>
                </c:pt>
                <c:pt idx="81">
                  <c:v>2.6447638603999999</c:v>
                </c:pt>
                <c:pt idx="82">
                  <c:v>2.6447638603999999</c:v>
                </c:pt>
                <c:pt idx="83">
                  <c:v>2.7980835044000001</c:v>
                </c:pt>
                <c:pt idx="84">
                  <c:v>2.7980835044000001</c:v>
                </c:pt>
                <c:pt idx="85">
                  <c:v>2.7980835044000001</c:v>
                </c:pt>
                <c:pt idx="86">
                  <c:v>3.0308008214000002</c:v>
                </c:pt>
                <c:pt idx="87">
                  <c:v>3.0308008214000002</c:v>
                </c:pt>
                <c:pt idx="88">
                  <c:v>3.0308008214000002</c:v>
                </c:pt>
              </c:numCache>
            </c:numRef>
          </c:xVal>
          <c:yVal>
            <c:numRef>
              <c:f>SuppFigure2_TTDM!$B$1:$B$3500</c:f>
              <c:numCache>
                <c:formatCode>General</c:formatCode>
                <c:ptCount val="350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2.85714286E-2</c:v>
                </c:pt>
                <c:pt idx="12">
                  <c:v>2.85714286E-2</c:v>
                </c:pt>
                <c:pt idx="13">
                  <c:v>2.85714286E-2</c:v>
                </c:pt>
                <c:pt idx="14">
                  <c:v>2.85714286E-2</c:v>
                </c:pt>
                <c:pt idx="15">
                  <c:v>5.71428571E-2</c:v>
                </c:pt>
                <c:pt idx="16">
                  <c:v>5.71428571E-2</c:v>
                </c:pt>
                <c:pt idx="17">
                  <c:v>8.5714285700000004E-2</c:v>
                </c:pt>
                <c:pt idx="18">
                  <c:v>8.5714285700000004E-2</c:v>
                </c:pt>
                <c:pt idx="19">
                  <c:v>8.5714285700000004E-2</c:v>
                </c:pt>
                <c:pt idx="20">
                  <c:v>8.5714285700000004E-2</c:v>
                </c:pt>
                <c:pt idx="21">
                  <c:v>8.5714285700000004E-2</c:v>
                </c:pt>
                <c:pt idx="22">
                  <c:v>8.5714285700000004E-2</c:v>
                </c:pt>
                <c:pt idx="23">
                  <c:v>8.5714285700000004E-2</c:v>
                </c:pt>
                <c:pt idx="24">
                  <c:v>8.5714285700000004E-2</c:v>
                </c:pt>
                <c:pt idx="25">
                  <c:v>8.5714285700000004E-2</c:v>
                </c:pt>
                <c:pt idx="26">
                  <c:v>8.5714285700000004E-2</c:v>
                </c:pt>
                <c:pt idx="27">
                  <c:v>8.5714285700000004E-2</c:v>
                </c:pt>
                <c:pt idx="28">
                  <c:v>8.5714285700000004E-2</c:v>
                </c:pt>
                <c:pt idx="29">
                  <c:v>8.5714285700000004E-2</c:v>
                </c:pt>
                <c:pt idx="30">
                  <c:v>8.5714285700000004E-2</c:v>
                </c:pt>
                <c:pt idx="31">
                  <c:v>0.10571428569999999</c:v>
                </c:pt>
                <c:pt idx="32">
                  <c:v>8.5714285700000004E-2</c:v>
                </c:pt>
                <c:pt idx="33">
                  <c:v>8.5714285700000004E-2</c:v>
                </c:pt>
                <c:pt idx="34">
                  <c:v>0.10571428569999999</c:v>
                </c:pt>
                <c:pt idx="35">
                  <c:v>8.5714285700000004E-2</c:v>
                </c:pt>
                <c:pt idx="36">
                  <c:v>8.5714285700000004E-2</c:v>
                </c:pt>
                <c:pt idx="37">
                  <c:v>0.10571428569999999</c:v>
                </c:pt>
                <c:pt idx="38">
                  <c:v>8.5714285700000004E-2</c:v>
                </c:pt>
                <c:pt idx="39">
                  <c:v>8.5714285700000004E-2</c:v>
                </c:pt>
                <c:pt idx="40">
                  <c:v>0.11904761899999999</c:v>
                </c:pt>
                <c:pt idx="41">
                  <c:v>0.11904761899999999</c:v>
                </c:pt>
                <c:pt idx="42">
                  <c:v>0.15238095239999999</c:v>
                </c:pt>
                <c:pt idx="43">
                  <c:v>0.15238095239999999</c:v>
                </c:pt>
                <c:pt idx="44">
                  <c:v>0.17238095240000001</c:v>
                </c:pt>
                <c:pt idx="45">
                  <c:v>0.15238095239999999</c:v>
                </c:pt>
                <c:pt idx="46">
                  <c:v>0.15238095239999999</c:v>
                </c:pt>
                <c:pt idx="47">
                  <c:v>0.17238095240000001</c:v>
                </c:pt>
                <c:pt idx="48">
                  <c:v>0.15238095239999999</c:v>
                </c:pt>
                <c:pt idx="49">
                  <c:v>0.15238095239999999</c:v>
                </c:pt>
                <c:pt idx="50">
                  <c:v>0.15238095239999999</c:v>
                </c:pt>
                <c:pt idx="51">
                  <c:v>0.15238095239999999</c:v>
                </c:pt>
                <c:pt idx="52">
                  <c:v>0.17238095240000001</c:v>
                </c:pt>
                <c:pt idx="53">
                  <c:v>0.15238095239999999</c:v>
                </c:pt>
                <c:pt idx="54">
                  <c:v>0.15238095239999999</c:v>
                </c:pt>
                <c:pt idx="55">
                  <c:v>0.17238095240000001</c:v>
                </c:pt>
                <c:pt idx="56">
                  <c:v>0.15238095239999999</c:v>
                </c:pt>
                <c:pt idx="57">
                  <c:v>0.15238095239999999</c:v>
                </c:pt>
                <c:pt idx="58">
                  <c:v>0.17238095240000001</c:v>
                </c:pt>
                <c:pt idx="59">
                  <c:v>0.15238095239999999</c:v>
                </c:pt>
                <c:pt idx="60">
                  <c:v>0.15238095239999999</c:v>
                </c:pt>
                <c:pt idx="61">
                  <c:v>0.17238095240000001</c:v>
                </c:pt>
                <c:pt idx="62">
                  <c:v>0.15238095239999999</c:v>
                </c:pt>
                <c:pt idx="63">
                  <c:v>0.15238095239999999</c:v>
                </c:pt>
                <c:pt idx="64">
                  <c:v>0.17238095240000001</c:v>
                </c:pt>
                <c:pt idx="65">
                  <c:v>0.15238095239999999</c:v>
                </c:pt>
                <c:pt idx="66">
                  <c:v>0.15238095239999999</c:v>
                </c:pt>
                <c:pt idx="67">
                  <c:v>0.17238095240000001</c:v>
                </c:pt>
                <c:pt idx="68">
                  <c:v>0.15238095239999999</c:v>
                </c:pt>
                <c:pt idx="69">
                  <c:v>0.15238095239999999</c:v>
                </c:pt>
                <c:pt idx="70">
                  <c:v>0.17238095240000001</c:v>
                </c:pt>
                <c:pt idx="71">
                  <c:v>0.15238095239999999</c:v>
                </c:pt>
                <c:pt idx="72">
                  <c:v>0.15238095239999999</c:v>
                </c:pt>
                <c:pt idx="73">
                  <c:v>0.17238095240000001</c:v>
                </c:pt>
                <c:pt idx="74">
                  <c:v>0.15238095239999999</c:v>
                </c:pt>
                <c:pt idx="75">
                  <c:v>0.15238095239999999</c:v>
                </c:pt>
                <c:pt idx="76">
                  <c:v>0.17238095240000001</c:v>
                </c:pt>
                <c:pt idx="77">
                  <c:v>0.15238095239999999</c:v>
                </c:pt>
                <c:pt idx="78">
                  <c:v>0.15238095239999999</c:v>
                </c:pt>
                <c:pt idx="79">
                  <c:v>0.15238095239999999</c:v>
                </c:pt>
                <c:pt idx="80">
                  <c:v>0.15238095239999999</c:v>
                </c:pt>
                <c:pt idx="81">
                  <c:v>0.17238095240000001</c:v>
                </c:pt>
                <c:pt idx="82">
                  <c:v>0.15238095239999999</c:v>
                </c:pt>
                <c:pt idx="83">
                  <c:v>0.15238095239999999</c:v>
                </c:pt>
                <c:pt idx="84">
                  <c:v>0.17238095240000001</c:v>
                </c:pt>
                <c:pt idx="85">
                  <c:v>0.15238095239999999</c:v>
                </c:pt>
                <c:pt idx="86">
                  <c:v>0.15238095239999999</c:v>
                </c:pt>
                <c:pt idx="87">
                  <c:v>0.17238095240000001</c:v>
                </c:pt>
                <c:pt idx="88">
                  <c:v>0.1523809523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609-AE43-980C-A20CB23156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993024096"/>
        <c:axId val="-1992470672"/>
      </c:scatterChart>
      <c:valAx>
        <c:axId val="-1993024096"/>
        <c:scaling>
          <c:orientation val="minMax"/>
          <c:max val="4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600"/>
            </a:pPr>
            <a:endParaRPr lang="ja-JP"/>
          </a:p>
        </c:txPr>
        <c:crossAx val="-1992470672"/>
        <c:crosses val="autoZero"/>
        <c:crossBetween val="midCat"/>
        <c:majorUnit val="0.5"/>
      </c:valAx>
      <c:valAx>
        <c:axId val="-1992470672"/>
        <c:scaling>
          <c:orientation val="minMax"/>
          <c:max val="1.05"/>
          <c:min val="0"/>
        </c:scaling>
        <c:delete val="0"/>
        <c:axPos val="l"/>
        <c:numFmt formatCode="0.0_ " sourceLinked="0"/>
        <c:majorTickMark val="in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600"/>
            </a:pPr>
            <a:endParaRPr lang="ja-JP"/>
          </a:p>
        </c:txPr>
        <c:crossAx val="-1993024096"/>
        <c:crosses val="autoZero"/>
        <c:crossBetween val="midCat"/>
        <c:majorUnit val="0.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050" b="0" i="0" u="none" strike="noStrike" baseline="0">
          <a:solidFill>
            <a:srgbClr val="000000"/>
          </a:solidFill>
          <a:latin typeface="Arial" charset="0"/>
          <a:ea typeface="Arial" charset="0"/>
          <a:cs typeface="Arial" charset="0"/>
        </a:defRPr>
      </a:pPr>
      <a:endParaRPr lang="ja-JP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3245</cdr:x>
      <cdr:y>0.91012</cdr:y>
    </cdr:from>
    <cdr:to>
      <cdr:x>0.70652</cdr:x>
      <cdr:y>0.97009</cdr:y>
    </cdr:to>
    <cdr:sp macro="" textlink="">
      <cdr:nvSpPr>
        <cdr:cNvPr id="2049" name="Text Box 1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710211" y="1926643"/>
          <a:ext cx="799120" cy="12695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FFFFFF" mc:Ignorable="a14" a14:legacySpreadsheetColorIndex="9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xmlns:mc="http://schemas.openxmlformats.org/markup-compatibility/2006" val="000000" mc:Ignorable="a14" a14:legacySpreadsheetColorIndex="64"/>
              </a:solidFill>
              <a:miter lim="800000"/>
              <a:headEnd/>
              <a:tailEnd/>
            </a14:hiddenLine>
          </a:ext>
        </a:extLst>
      </cdr:spPr>
      <cdr:txBody>
        <a:bodyPr xmlns:a="http://schemas.openxmlformats.org/drawingml/2006/main" wrap="none" lIns="18288" tIns="18288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en-US" altLang="ja-JP" sz="600" b="0" i="0" u="none" strike="noStrike" baseline="0" dirty="0">
              <a:solidFill>
                <a:srgbClr val="000000"/>
              </a:solidFill>
              <a:latin typeface="Arial" panose="020B0604020202020204" pitchFamily="34" charset="0"/>
              <a:ea typeface="ＭＳ Ｐゴシック"/>
              <a:cs typeface="Arial" panose="020B0604020202020204" pitchFamily="34" charset="0"/>
            </a:rPr>
            <a:t>Years after registration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570326-6E3D-D647-8EE3-124D648D0C9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5B604E-E260-2A48-BE7D-FC4D25AA3C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568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716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620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1343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4421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8829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8455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3775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7971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9978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38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5112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0F1B2-46C7-2A48-95C7-84CE76D0CD85}" type="datetimeFigureOut">
              <a:rPr kumimoji="1" lang="ja-JP" altLang="en-US" smtClean="0"/>
              <a:t>2019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A7461A-A92F-8848-BF70-691B33CFD8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927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1762389"/>
              </p:ext>
            </p:extLst>
          </p:nvPr>
        </p:nvGraphicFramePr>
        <p:xfrm>
          <a:off x="2027640" y="2102912"/>
          <a:ext cx="2912568" cy="1292484"/>
        </p:xfrm>
        <a:graphic>
          <a:graphicData uri="http://schemas.openxmlformats.org/drawingml/2006/table">
            <a:tbl>
              <a:tblPr firstRow="1" firstCol="1" bandRow="1"/>
              <a:tblGrid>
                <a:gridCol w="5305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27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27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3277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2219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3101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3052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15414">
                <a:tc gridSpan="7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7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tage distribution of </a:t>
                      </a:r>
                      <a:r>
                        <a:rPr lang="en-US" sz="700" b="1" kern="0" dirty="0">
                          <a:solidFill>
                            <a:srgbClr val="0070C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P</a:t>
                      </a:r>
                      <a:r>
                        <a:rPr lang="en-US" sz="7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700" b="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</a:t>
                      </a:r>
                      <a:r>
                        <a:rPr lang="en-US" sz="700" b="0" i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</a:t>
                      </a:r>
                      <a:r>
                        <a:rPr lang="en-US" sz="700" b="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=35)</a:t>
                      </a:r>
                      <a:endParaRPr lang="ja-JP" sz="700" b="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5414">
                <a:tc>
                  <a:txBody>
                    <a:bodyPr/>
                    <a:lstStyle/>
                    <a:p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1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2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3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4a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4b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otal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541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2b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5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541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2c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7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6</a:t>
                      </a:r>
                      <a:endParaRPr lang="ja-JP" sz="600" kern="10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541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3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541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otal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600" kern="10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1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4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5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3825777"/>
              </p:ext>
            </p:extLst>
          </p:nvPr>
        </p:nvGraphicFramePr>
        <p:xfrm>
          <a:off x="2027639" y="4951268"/>
          <a:ext cx="537503" cy="189115"/>
        </p:xfrm>
        <a:graphic>
          <a:graphicData uri="http://schemas.openxmlformats.org/drawingml/2006/table">
            <a:tbl>
              <a:tblPr firstRow="1" firstCol="1" bandRow="1"/>
              <a:tblGrid>
                <a:gridCol w="5375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946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Stage IVA 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69" marR="35369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44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Stage IVB 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69" marR="35369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0120118"/>
              </p:ext>
            </p:extLst>
          </p:nvPr>
        </p:nvGraphicFramePr>
        <p:xfrm>
          <a:off x="2027640" y="3518394"/>
          <a:ext cx="2912569" cy="1309876"/>
        </p:xfrm>
        <a:graphic>
          <a:graphicData uri="http://schemas.openxmlformats.org/drawingml/2006/table">
            <a:tbl>
              <a:tblPr firstRow="1" firstCol="1" bandRow="1"/>
              <a:tblGrid>
                <a:gridCol w="5305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27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27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3277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2219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3101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3052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85551">
                <a:tc gridSpan="7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700" b="1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Stage distribution of </a:t>
                      </a:r>
                      <a:r>
                        <a:rPr lang="en-US" sz="700" b="1" kern="0" dirty="0"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FAS</a:t>
                      </a:r>
                      <a:r>
                        <a:rPr lang="en-US" sz="700" b="1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 </a:t>
                      </a:r>
                      <a:r>
                        <a:rPr lang="en-US" sz="700" b="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(</a:t>
                      </a:r>
                      <a:r>
                        <a:rPr lang="en-US" sz="700" b="0" i="1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n</a:t>
                      </a:r>
                      <a:r>
                        <a:rPr lang="en-US" sz="700" b="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=32)</a:t>
                      </a:r>
                      <a:endParaRPr lang="ja-JP" sz="700" b="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4865">
                <a:tc>
                  <a:txBody>
                    <a:bodyPr/>
                    <a:lstStyle/>
                    <a:p>
                      <a:endParaRPr lang="ja-JP" sz="600" kern="100" dirty="0">
                        <a:effectLst/>
                        <a:latin typeface="Arial" charset="0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600" b="1" dirty="0">
                          <a:latin typeface="+mn-lt"/>
                        </a:rPr>
                        <a:t>T1</a:t>
                      </a:r>
                      <a:endParaRPr lang="ja-JP" altLang="en-US" sz="600" b="1" dirty="0">
                        <a:latin typeface="+mn-lt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+mn-lt"/>
                          <a:ea typeface="ＭＳ Ｐゴシック" charset="-128"/>
                          <a:cs typeface="Arial" charset="0"/>
                        </a:rPr>
                        <a:t>T2</a:t>
                      </a:r>
                      <a:endParaRPr lang="ja-JP" sz="600" kern="100" dirty="0">
                        <a:effectLst/>
                        <a:latin typeface="+mn-lt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+mn-lt"/>
                          <a:ea typeface="ＭＳ Ｐゴシック" charset="-128"/>
                          <a:cs typeface="Arial" charset="0"/>
                        </a:rPr>
                        <a:t>T3</a:t>
                      </a:r>
                      <a:endParaRPr lang="ja-JP" sz="600" kern="100" dirty="0">
                        <a:effectLst/>
                        <a:latin typeface="+mn-lt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+mn-lt"/>
                          <a:ea typeface="ＭＳ Ｐゴシック" charset="-128"/>
                          <a:cs typeface="Arial" charset="0"/>
                        </a:rPr>
                        <a:t>T4a</a:t>
                      </a:r>
                      <a:endParaRPr lang="ja-JP" sz="600" kern="100" dirty="0">
                        <a:effectLst/>
                        <a:latin typeface="+mn-lt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+mn-lt"/>
                          <a:ea typeface="ＭＳ Ｐゴシック" charset="-128"/>
                          <a:cs typeface="Arial" charset="0"/>
                        </a:rPr>
                        <a:t>T4b</a:t>
                      </a:r>
                      <a:endParaRPr lang="ja-JP" sz="600" kern="100" dirty="0">
                        <a:effectLst/>
                        <a:latin typeface="+mn-lt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Total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486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N2b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600" dirty="0"/>
                        <a:t>0</a:t>
                      </a:r>
                      <a:endParaRPr lang="ja-JP" altLang="en-US" sz="600" dirty="0"/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2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1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6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4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13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486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N2c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600" dirty="0"/>
                        <a:t>0</a:t>
                      </a:r>
                      <a:endParaRPr lang="ja-JP" altLang="en-US" sz="600" dirty="0"/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7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4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4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0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15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486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N3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600" dirty="0"/>
                        <a:t>0</a:t>
                      </a:r>
                      <a:endParaRPr lang="ja-JP" altLang="en-US" sz="600" dirty="0"/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1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0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3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0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4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486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Total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600" dirty="0"/>
                        <a:t>0</a:t>
                      </a:r>
                      <a:endParaRPr lang="ja-JP" altLang="en-US" sz="600" dirty="0"/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10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5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13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4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32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49" marR="35349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664113" y="1472531"/>
            <a:ext cx="67333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" charset="0"/>
                <a:ea typeface="Arial" charset="0"/>
                <a:cs typeface="Arial" charset="0"/>
              </a:rPr>
              <a:t>Fig. S1.</a:t>
            </a:r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8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tage distribution</a:t>
            </a:r>
          </a:p>
        </p:txBody>
      </p:sp>
      <p:sp>
        <p:nvSpPr>
          <p:cNvPr id="7" name="正方形/長方形 6"/>
          <p:cNvSpPr/>
          <p:nvPr/>
        </p:nvSpPr>
        <p:spPr>
          <a:xfrm>
            <a:off x="2836872" y="4822332"/>
            <a:ext cx="2175229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SP, safety population; FAS, full analysis set. UICC/TNM 7</a:t>
            </a:r>
            <a:r>
              <a:rPr lang="en-US" altLang="ja-JP" sz="600" baseline="30000" dirty="0">
                <a:latin typeface="Arial" charset="0"/>
                <a:ea typeface="Arial" charset="0"/>
                <a:cs typeface="Arial" charset="0"/>
              </a:rPr>
              <a:t>th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. </a:t>
            </a:r>
            <a:endParaRPr lang="ja-JP" altLang="en-US" sz="6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4204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490219" y="1403087"/>
            <a:ext cx="67333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" charset="0"/>
                <a:ea typeface="Arial" charset="0"/>
                <a:cs typeface="Arial" charset="0"/>
              </a:rPr>
              <a:t>Fig. S2. 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RTOG0129 risk classification </a:t>
            </a:r>
            <a:r>
              <a:rPr lang="en-US" altLang="ja-JP" sz="8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of oropharyngeal cancer</a:t>
            </a:r>
            <a:endParaRPr lang="ja-JP" altLang="ja-JP" sz="800" kern="1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1090950"/>
              </p:ext>
            </p:extLst>
          </p:nvPr>
        </p:nvGraphicFramePr>
        <p:xfrm>
          <a:off x="1351333" y="4394944"/>
          <a:ext cx="4263691" cy="182880"/>
        </p:xfrm>
        <a:graphic>
          <a:graphicData uri="http://schemas.openxmlformats.org/drawingml/2006/table">
            <a:tbl>
              <a:tblPr firstRow="1" firstCol="1" bandRow="1"/>
              <a:tblGrid>
                <a:gridCol w="5437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2541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368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2740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6341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800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0" baseline="0" dirty="0"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Low risk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0" dirty="0"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(</a:t>
                      </a:r>
                      <a:r>
                        <a:rPr lang="en-US" altLang="ja-JP" sz="600" i="1" kern="0" dirty="0"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n</a:t>
                      </a:r>
                      <a:r>
                        <a:rPr lang="en-US" altLang="ja-JP" sz="600" kern="0" dirty="0"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=0) 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0" baseline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Intermediate risk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(</a:t>
                      </a:r>
                      <a:r>
                        <a:rPr lang="en-US" altLang="ja-JP" sz="600" i="1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n</a:t>
                      </a:r>
                      <a:r>
                        <a:rPr lang="en-US" altLang="ja-JP" sz="600" kern="0" dirty="0">
                          <a:effectLst/>
                          <a:latin typeface="Arial" charset="0"/>
                          <a:ea typeface="ＭＳ Ｐゴシック" charset="-128"/>
                          <a:cs typeface="Arial" charset="0"/>
                        </a:rPr>
                        <a:t>=9) 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667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600" b="1" kern="0" baseline="0" dirty="0"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High risk </a:t>
                      </a:r>
                      <a:br>
                        <a:rPr lang="en-US" altLang="ja-JP" sz="600" b="1" kern="0" baseline="0" dirty="0">
                          <a:effectLst/>
                          <a:latin typeface="Arial" charset="0"/>
                          <a:ea typeface="+mn-ea"/>
                          <a:cs typeface="Arial" charset="0"/>
                        </a:rPr>
                      </a:br>
                      <a:r>
                        <a:rPr lang="en-US" altLang="ja-JP" sz="600" kern="0" dirty="0"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(</a:t>
                      </a:r>
                      <a:r>
                        <a:rPr lang="en-US" altLang="ja-JP" sz="600" i="1" kern="0" dirty="0"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n</a:t>
                      </a:r>
                      <a:r>
                        <a:rPr lang="en-US" altLang="ja-JP" sz="600" kern="0" dirty="0"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=2) </a:t>
                      </a:r>
                      <a:endParaRPr lang="ja-JP" alt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Intermediate or High risk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(</a:t>
                      </a:r>
                      <a:r>
                        <a:rPr lang="en-US" altLang="ja-JP" sz="600" i="1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n</a:t>
                      </a:r>
                      <a:r>
                        <a:rPr lang="en-US" altLang="ja-JP" sz="600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=3) 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High</a:t>
                      </a:r>
                      <a:r>
                        <a:rPr lang="en-US" altLang="ja-JP" sz="600" b="1" kern="100" baseline="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 or low risk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kern="100" baseline="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(</a:t>
                      </a:r>
                      <a:r>
                        <a:rPr lang="en-US" altLang="ja-JP" sz="600" i="1" kern="100" baseline="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n</a:t>
                      </a:r>
                      <a:r>
                        <a:rPr lang="en-US" altLang="ja-JP" sz="600" kern="100" baseline="0" dirty="0">
                          <a:effectLst/>
                          <a:latin typeface="Arial" charset="0"/>
                          <a:ea typeface="ＭＳ Ｐゴシック" charset="-128"/>
                          <a:cs typeface="Times New Roman" charset="0"/>
                        </a:rPr>
                        <a:t>=2)</a:t>
                      </a:r>
                      <a:endParaRPr lang="ja-JP" sz="60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8EF3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3211426" y="4577824"/>
            <a:ext cx="2539478" cy="184666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sk-SK" altLang="ja-JP" sz="600" baseline="30000" dirty="0">
                <a:latin typeface="Arial" charset="0"/>
              </a:rPr>
              <a:t>†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Oropharyngeal cancer patients among FAS (full analysis set) cases.</a:t>
            </a:r>
            <a:endParaRPr lang="ja-JP" altLang="en-US" sz="6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08538"/>
              </p:ext>
            </p:extLst>
          </p:nvPr>
        </p:nvGraphicFramePr>
        <p:xfrm>
          <a:off x="2885432" y="4249837"/>
          <a:ext cx="1066205" cy="111621"/>
        </p:xfrm>
        <a:graphic>
          <a:graphicData uri="http://schemas.openxmlformats.org/drawingml/2006/table">
            <a:tbl>
              <a:tblPr firstRow="1" firstCol="1" bandRow="1"/>
              <a:tblGrid>
                <a:gridCol w="10662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1162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i="1" kern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&lt;RTOG0129</a:t>
                      </a:r>
                      <a:r>
                        <a:rPr lang="en-US" altLang="ja-JP" sz="600" b="1" i="1" kern="0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 </a:t>
                      </a:r>
                      <a:r>
                        <a:rPr lang="en-US" altLang="ja-JP" sz="600" b="1" i="1" kern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Arial" charset="0"/>
                        </a:rPr>
                        <a:t>criteria&gt;</a:t>
                      </a:r>
                      <a:endParaRPr lang="ja-JP" sz="600" b="1" i="1" kern="1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96" marR="35396" marT="0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5346625"/>
              </p:ext>
            </p:extLst>
          </p:nvPr>
        </p:nvGraphicFramePr>
        <p:xfrm>
          <a:off x="1351333" y="2068751"/>
          <a:ext cx="4263692" cy="1843409"/>
        </p:xfrm>
        <a:graphic>
          <a:graphicData uri="http://schemas.openxmlformats.org/drawingml/2006/table">
            <a:tbl>
              <a:tblPr firstRow="1" firstCol="1" bandRow="1"/>
              <a:tblGrid>
                <a:gridCol w="4339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884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884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758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3884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3884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583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3884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3884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7583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38849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238849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75838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815601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</a:tblGrid>
              <a:tr h="197760">
                <a:tc gridSpan="14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b="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</a:t>
                      </a:r>
                      <a:r>
                        <a:rPr lang="en-US" altLang="ja-JP" sz="700" b="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=16</a:t>
                      </a:r>
                      <a:r>
                        <a:rPr kumimoji="1" lang="sk-SK" altLang="ja-JP" sz="7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+mn-cs"/>
                        </a:rPr>
                        <a:t>†</a:t>
                      </a:r>
                      <a:endParaRPr lang="ja-JP" sz="700" b="0" kern="100" dirty="0">
                        <a:effectLst/>
                        <a:latin typeface="Arial" charset="0"/>
                        <a:ea typeface="ＭＳ Ｐゴシック" charset="-128"/>
                        <a:cs typeface="Times New Roman" charset="0"/>
                      </a:endParaRPr>
                    </a:p>
                  </a:txBody>
                  <a:tcPr marL="35362" marR="35362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7027">
                <a:tc>
                  <a:txBody>
                    <a:bodyPr/>
                    <a:lstStyle/>
                    <a:p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2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3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4a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4b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9828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2b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≤ 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 pack</a:t>
                      </a:r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・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ar</a:t>
                      </a:r>
                      <a:endParaRPr lang="ja-JP" altLang="en-US" sz="600" b="1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982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gt;</a:t>
                      </a:r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 pack</a:t>
                      </a:r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・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ar</a:t>
                      </a:r>
                      <a:endParaRPr lang="ja-JP" altLang="en-US" sz="600" b="1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9828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2c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≤ 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 pack</a:t>
                      </a:r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・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ar</a:t>
                      </a:r>
                      <a:endParaRPr lang="ja-JP" altLang="en-US" sz="600" b="1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982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gt;</a:t>
                      </a:r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 pack</a:t>
                      </a:r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・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ar</a:t>
                      </a:r>
                      <a:endParaRPr lang="ja-JP" altLang="en-US" sz="600" b="1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9828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3</a:t>
                      </a:r>
                      <a:endParaRPr lang="ja-JP" sz="6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E8EF3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≤ 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 pack</a:t>
                      </a:r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・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ar</a:t>
                      </a:r>
                      <a:endParaRPr lang="ja-JP" altLang="en-US" sz="600" b="1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982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FF8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E7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700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&gt;</a:t>
                      </a:r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 pack</a:t>
                      </a:r>
                      <a:r>
                        <a:rPr kumimoji="1" lang="ja-JP" altLang="en-US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・</a:t>
                      </a:r>
                      <a:r>
                        <a:rPr kumimoji="1" lang="en-US" altLang="ja-JP" sz="600" b="1" kern="12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ar</a:t>
                      </a:r>
                      <a:endParaRPr lang="ja-JP" altLang="en-US" sz="600" b="1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5965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700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+)</a:t>
                      </a: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-)</a:t>
                      </a: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  <a:endParaRPr lang="en-US" altLang="ja-JP" sz="600" b="1" kern="100" baseline="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baseline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K</a:t>
                      </a:r>
                      <a:endParaRPr lang="en-US" altLang="ja-JP" sz="600" b="1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+)</a:t>
                      </a: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-)</a:t>
                      </a: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  <a:endParaRPr lang="en-US" altLang="ja-JP" sz="600" b="1" kern="100" baseline="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baseline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K</a:t>
                      </a:r>
                      <a:endParaRPr lang="en-US" altLang="ja-JP" sz="600" b="1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+)</a:t>
                      </a: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-)</a:t>
                      </a: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  <a:endParaRPr lang="en-US" altLang="ja-JP" sz="600" b="1" kern="100" baseline="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baseline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K</a:t>
                      </a:r>
                      <a:endParaRPr lang="en-US" altLang="ja-JP" sz="600" b="1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+)</a:t>
                      </a:r>
                    </a:p>
                  </a:txBody>
                  <a:tcPr marL="35362" marR="3536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-)</a:t>
                      </a: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16</a:t>
                      </a:r>
                      <a:endParaRPr lang="en-US" altLang="ja-JP" sz="600" b="1" kern="100" baseline="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600" b="1" kern="100" baseline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K</a:t>
                      </a:r>
                      <a:endParaRPr lang="en-US" altLang="ja-JP" sz="600" b="1" kern="100" dirty="0"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952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7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5362" marR="3536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7" name="下矢印 27"/>
          <p:cNvSpPr>
            <a:spLocks noChangeArrowheads="1"/>
          </p:cNvSpPr>
          <p:nvPr/>
        </p:nvSpPr>
        <p:spPr bwMode="auto">
          <a:xfrm>
            <a:off x="3229158" y="3969449"/>
            <a:ext cx="167432" cy="251181"/>
          </a:xfrm>
          <a:prstGeom prst="downArrow">
            <a:avLst>
              <a:gd name="adj1" fmla="val 50000"/>
              <a:gd name="adj2" fmla="val 50070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>
            <a:lvl1pPr defTabSz="2508250">
              <a:defRPr sz="2500">
                <a:solidFill>
                  <a:schemeClr val="tx1"/>
                </a:solidFill>
                <a:latin typeface="Arial Narrow" charset="0"/>
                <a:ea typeface="ＭＳ Ｐゴシック" charset="-128"/>
              </a:defRPr>
            </a:lvl1pPr>
            <a:lvl2pPr defTabSz="2508250">
              <a:defRPr sz="2500">
                <a:solidFill>
                  <a:schemeClr val="tx1"/>
                </a:solidFill>
                <a:latin typeface="Arial Narrow" charset="0"/>
                <a:ea typeface="ＭＳ Ｐゴシック" charset="-128"/>
              </a:defRPr>
            </a:lvl2pPr>
            <a:lvl3pPr defTabSz="2508250">
              <a:defRPr sz="2500">
                <a:solidFill>
                  <a:schemeClr val="tx1"/>
                </a:solidFill>
                <a:latin typeface="Arial Narrow" charset="0"/>
                <a:ea typeface="ＭＳ Ｐゴシック" charset="-128"/>
              </a:defRPr>
            </a:lvl3pPr>
            <a:lvl4pPr defTabSz="2508250">
              <a:defRPr sz="2500">
                <a:solidFill>
                  <a:schemeClr val="tx1"/>
                </a:solidFill>
                <a:latin typeface="Arial Narrow" charset="0"/>
                <a:ea typeface="ＭＳ Ｐゴシック" charset="-128"/>
              </a:defRPr>
            </a:lvl4pPr>
            <a:lvl5pPr defTabSz="2508250">
              <a:defRPr sz="2500">
                <a:solidFill>
                  <a:schemeClr val="tx1"/>
                </a:solidFill>
                <a:latin typeface="Arial Narrow" charset="0"/>
                <a:ea typeface="ＭＳ Ｐゴシック" charset="-128"/>
              </a:defRPr>
            </a:lvl5pPr>
            <a:lvl6pPr marL="3124200" indent="-838200" defTabSz="2508250" eaLnBrk="0" fontAlgn="base" hangingPunct="0">
              <a:spcBef>
                <a:spcPct val="0"/>
              </a:spcBef>
              <a:spcAft>
                <a:spcPct val="0"/>
              </a:spcAft>
              <a:defRPr sz="2500">
                <a:solidFill>
                  <a:schemeClr val="tx1"/>
                </a:solidFill>
                <a:latin typeface="Arial Narrow" charset="0"/>
                <a:ea typeface="ＭＳ Ｐゴシック" charset="-128"/>
              </a:defRPr>
            </a:lvl6pPr>
            <a:lvl7pPr marL="3581400" indent="-838200" defTabSz="2508250" eaLnBrk="0" fontAlgn="base" hangingPunct="0">
              <a:spcBef>
                <a:spcPct val="0"/>
              </a:spcBef>
              <a:spcAft>
                <a:spcPct val="0"/>
              </a:spcAft>
              <a:defRPr sz="2500">
                <a:solidFill>
                  <a:schemeClr val="tx1"/>
                </a:solidFill>
                <a:latin typeface="Arial Narrow" charset="0"/>
                <a:ea typeface="ＭＳ Ｐゴシック" charset="-128"/>
              </a:defRPr>
            </a:lvl7pPr>
            <a:lvl8pPr marL="4038600" indent="-838200" defTabSz="2508250" eaLnBrk="0" fontAlgn="base" hangingPunct="0">
              <a:spcBef>
                <a:spcPct val="0"/>
              </a:spcBef>
              <a:spcAft>
                <a:spcPct val="0"/>
              </a:spcAft>
              <a:defRPr sz="2500">
                <a:solidFill>
                  <a:schemeClr val="tx1"/>
                </a:solidFill>
                <a:latin typeface="Arial Narrow" charset="0"/>
                <a:ea typeface="ＭＳ Ｐゴシック" charset="-128"/>
              </a:defRPr>
            </a:lvl8pPr>
            <a:lvl9pPr marL="4495800" indent="-838200" defTabSz="2508250" eaLnBrk="0" fontAlgn="base" hangingPunct="0">
              <a:spcBef>
                <a:spcPct val="0"/>
              </a:spcBef>
              <a:spcAft>
                <a:spcPct val="0"/>
              </a:spcAft>
              <a:defRPr sz="2500">
                <a:solidFill>
                  <a:schemeClr val="tx1"/>
                </a:solidFill>
                <a:latin typeface="Arial Narrow" charset="0"/>
                <a:ea typeface="ＭＳ Ｐゴシック" charset="-128"/>
              </a:defRPr>
            </a:lvl9pPr>
          </a:lstStyle>
          <a:p>
            <a:pPr eaLnBrk="1" hangingPunct="1"/>
            <a:endParaRPr lang="ja-JP" altLang="en-US" sz="60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37448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テキスト ボックス 74"/>
          <p:cNvSpPr txBox="1"/>
          <p:nvPr/>
        </p:nvSpPr>
        <p:spPr>
          <a:xfrm>
            <a:off x="3958091" y="1986794"/>
            <a:ext cx="6209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Arial" charset="0"/>
                <a:ea typeface="Arial" charset="0"/>
                <a:cs typeface="Arial" charset="0"/>
              </a:rPr>
              <a:t>B</a:t>
            </a:r>
            <a:endParaRPr lang="ja-JP" altLang="en-US" sz="7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正方形/長方形 36"/>
          <p:cNvSpPr/>
          <p:nvPr/>
        </p:nvSpPr>
        <p:spPr>
          <a:xfrm>
            <a:off x="1656484" y="1979897"/>
            <a:ext cx="107273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700" b="1" dirty="0">
                <a:latin typeface="Arial" charset="0"/>
                <a:ea typeface="Arial" charset="0"/>
                <a:cs typeface="Arial" charset="0"/>
              </a:rPr>
              <a:t>Overall survival (OS)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1049225" y="2002918"/>
            <a:ext cx="6209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>
                <a:latin typeface="Arial" charset="0"/>
                <a:ea typeface="Arial" charset="0"/>
                <a:cs typeface="Arial" charset="0"/>
              </a:rPr>
              <a:t>A</a:t>
            </a:r>
            <a:endParaRPr lang="ja-JP" altLang="en-US" sz="7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4" name="正方形/長方形 73"/>
          <p:cNvSpPr/>
          <p:nvPr/>
        </p:nvSpPr>
        <p:spPr>
          <a:xfrm>
            <a:off x="4461594" y="1973342"/>
            <a:ext cx="124906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700" b="1">
                <a:latin typeface="Arial" charset="0"/>
                <a:ea typeface="Arial" charset="0"/>
                <a:cs typeface="Arial" charset="0"/>
              </a:rPr>
              <a:t>Event-free survival (EFS)</a:t>
            </a:r>
            <a:endParaRPr lang="en-US" altLang="ja-JP" sz="7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 rot="16200000">
            <a:off x="624187" y="3048124"/>
            <a:ext cx="575799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Arial" charset="0"/>
                <a:ea typeface="Arial" charset="0"/>
                <a:cs typeface="Arial" charset="0"/>
              </a:rPr>
              <a:t>Probability</a:t>
            </a:r>
            <a:endParaRPr lang="ja-JP" altLang="en-US" sz="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577418" y="4283817"/>
            <a:ext cx="703716" cy="2901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No. at Risk</a:t>
            </a:r>
            <a:endParaRPr lang="ja-JP" altLang="en-US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 rot="16200000">
            <a:off x="3475045" y="3040376"/>
            <a:ext cx="575799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Arial" charset="0"/>
                <a:ea typeface="Arial" charset="0"/>
                <a:cs typeface="Arial" charset="0"/>
              </a:rPr>
              <a:t>Probability</a:t>
            </a:r>
            <a:endParaRPr lang="ja-JP" altLang="en-US" sz="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3472419" y="4291316"/>
            <a:ext cx="560824" cy="14789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No. at Risk</a:t>
            </a:r>
            <a:endParaRPr lang="ja-JP" altLang="en-US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962489" y="4819329"/>
            <a:ext cx="6209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Arial" charset="0"/>
                <a:ea typeface="Arial" charset="0"/>
                <a:cs typeface="Arial" charset="0"/>
              </a:rPr>
              <a:t>D</a:t>
            </a:r>
            <a:endParaRPr lang="ja-JP" altLang="en-US" sz="7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1341513" y="4819328"/>
            <a:ext cx="159851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700" b="1" dirty="0">
                <a:latin typeface="Arial" charset="0"/>
                <a:ea typeface="Arial" charset="0"/>
                <a:cs typeface="Arial" charset="0"/>
              </a:rPr>
              <a:t>Time-to-local progression (TTLP)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038622" y="4836107"/>
            <a:ext cx="6209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Arial" charset="0"/>
                <a:ea typeface="Arial" charset="0"/>
                <a:cs typeface="Arial" charset="0"/>
              </a:rPr>
              <a:t>C</a:t>
            </a:r>
            <a:endParaRPr lang="ja-JP" altLang="en-US" sz="7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4309951" y="4811501"/>
            <a:ext cx="1661032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700" b="1" dirty="0">
                <a:latin typeface="Arial" charset="0"/>
                <a:ea typeface="Arial" charset="0"/>
                <a:cs typeface="Arial" charset="0"/>
              </a:rPr>
              <a:t>Time-to-distant metastasis (TTDM)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3529289" y="5860713"/>
            <a:ext cx="575799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91" b="1" dirty="0">
                <a:latin typeface="Arial" charset="0"/>
                <a:ea typeface="Arial" charset="0"/>
                <a:cs typeface="Arial" charset="0"/>
              </a:rPr>
              <a:t>Probability</a:t>
            </a:r>
            <a:endParaRPr lang="ja-JP" altLang="en-US" sz="591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3" name="グループ化 2"/>
          <p:cNvGrpSpPr/>
          <p:nvPr/>
        </p:nvGrpSpPr>
        <p:grpSpPr>
          <a:xfrm>
            <a:off x="3546535" y="7122221"/>
            <a:ext cx="1833218" cy="222439"/>
            <a:chOff x="-108426" y="3010067"/>
            <a:chExt cx="5337438" cy="381895"/>
          </a:xfrm>
        </p:grpSpPr>
        <p:sp>
          <p:nvSpPr>
            <p:cNvPr id="24" name="テキスト ボックス 23"/>
            <p:cNvSpPr txBox="1"/>
            <p:nvPr/>
          </p:nvSpPr>
          <p:spPr>
            <a:xfrm>
              <a:off x="3475434" y="3130352"/>
              <a:ext cx="478766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59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2844712" y="3130352"/>
              <a:ext cx="478765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59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4750246" y="3130352"/>
              <a:ext cx="478766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59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-108426" y="3010067"/>
              <a:ext cx="1632846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591" dirty="0">
                  <a:latin typeface="Arial" charset="0"/>
                  <a:ea typeface="Arial" charset="0"/>
                  <a:cs typeface="Arial" charset="0"/>
                </a:rPr>
                <a:t>No. at Risk</a:t>
              </a:r>
              <a:endParaRPr lang="ja-JP" altLang="en-US" sz="59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31" name="テキスト ボックス 30"/>
          <p:cNvSpPr txBox="1"/>
          <p:nvPr/>
        </p:nvSpPr>
        <p:spPr>
          <a:xfrm rot="16200000">
            <a:off x="634623" y="5906825"/>
            <a:ext cx="575799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91" b="1" dirty="0">
                <a:latin typeface="Arial" charset="0"/>
                <a:ea typeface="Arial" charset="0"/>
                <a:cs typeface="Arial" charset="0"/>
              </a:rPr>
              <a:t>Probability</a:t>
            </a:r>
            <a:endParaRPr lang="ja-JP" altLang="en-US" sz="591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37919" y="7137313"/>
            <a:ext cx="550534" cy="2901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591" dirty="0">
                <a:latin typeface="Arial" charset="0"/>
                <a:ea typeface="Arial" charset="0"/>
                <a:cs typeface="Arial" charset="0"/>
              </a:rPr>
              <a:t>No. at Risk</a:t>
            </a:r>
            <a:endParaRPr lang="ja-JP" altLang="en-US" sz="59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03864" y="1152452"/>
            <a:ext cx="58225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" charset="0"/>
                <a:ea typeface="Arial" charset="0"/>
                <a:cs typeface="Arial" charset="0"/>
              </a:rPr>
              <a:t>Fig. S3. (A)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 Overall survival, </a:t>
            </a:r>
            <a:r>
              <a:rPr lang="en-US" altLang="ja-JP" sz="800" b="1" dirty="0">
                <a:latin typeface="Arial" charset="0"/>
                <a:ea typeface="Arial" charset="0"/>
                <a:cs typeface="Arial" charset="0"/>
              </a:rPr>
              <a:t>(B)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 event-free survival, </a:t>
            </a:r>
            <a:r>
              <a:rPr lang="en-US" altLang="ja-JP" sz="800" b="1" dirty="0">
                <a:latin typeface="Arial" charset="0"/>
                <a:ea typeface="Arial" charset="0"/>
                <a:cs typeface="Arial" charset="0"/>
              </a:rPr>
              <a:t>(C)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 time-to-local progression and </a:t>
            </a:r>
            <a:r>
              <a:rPr lang="en-US" altLang="ja-JP" sz="800" b="1" dirty="0">
                <a:latin typeface="Arial" charset="0"/>
                <a:ea typeface="Arial" charset="0"/>
                <a:cs typeface="Arial" charset="0"/>
              </a:rPr>
              <a:t>(D)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 time-to-distant metastasis of patients treated with IC-PCE (SP). </a:t>
            </a:r>
          </a:p>
        </p:txBody>
      </p:sp>
      <p:graphicFrame>
        <p:nvGraphicFramePr>
          <p:cNvPr id="39" name="グラフ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1965288"/>
              </p:ext>
            </p:extLst>
          </p:nvPr>
        </p:nvGraphicFramePr>
        <p:xfrm>
          <a:off x="1007916" y="2212767"/>
          <a:ext cx="2136283" cy="21169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0" name="テキスト ボックス 39"/>
          <p:cNvSpPr txBox="1"/>
          <p:nvPr/>
        </p:nvSpPr>
        <p:spPr>
          <a:xfrm>
            <a:off x="1296632" y="3541650"/>
            <a:ext cx="10850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3-year OS (95%CI)</a:t>
            </a:r>
          </a:p>
          <a:p>
            <a:pPr algn="ctr"/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: 81.9% (60.7-92.3%)</a:t>
            </a: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102690" y="4286033"/>
            <a:ext cx="2180318" cy="1529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35      35      34       23       12       3         1        0         0 </a:t>
            </a:r>
            <a:endParaRPr lang="ja-JP" altLang="en-US" sz="6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42" name="グラフ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5517711"/>
              </p:ext>
            </p:extLst>
          </p:nvPr>
        </p:nvGraphicFramePr>
        <p:xfrm>
          <a:off x="3860902" y="2196726"/>
          <a:ext cx="2146500" cy="21100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3" name="テキスト ボックス 42"/>
          <p:cNvSpPr txBox="1"/>
          <p:nvPr/>
        </p:nvSpPr>
        <p:spPr>
          <a:xfrm>
            <a:off x="3946113" y="4293444"/>
            <a:ext cx="2180318" cy="1529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35       34      22       10       7         3        </a:t>
            </a:r>
            <a:r>
              <a:rPr lang="en-US" altLang="ja-JP" sz="600">
                <a:latin typeface="Arial" charset="0"/>
                <a:ea typeface="Arial" charset="0"/>
                <a:cs typeface="Arial" charset="0"/>
              </a:rPr>
              <a:t>1         0         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0 </a:t>
            </a:r>
            <a:endParaRPr lang="ja-JP" altLang="en-US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6" name="Text Box 1"/>
          <p:cNvSpPr txBox="1">
            <a:spLocks noChangeArrowheads="1"/>
          </p:cNvSpPr>
          <p:nvPr/>
        </p:nvSpPr>
        <p:spPr bwMode="auto">
          <a:xfrm>
            <a:off x="4572884" y="4116323"/>
            <a:ext cx="799120" cy="126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xmlns:mc="http://schemas.openxmlformats.org/markup-compatibility/2006" val="FFFFFF" mc:Ignorable="a14" a14:legacySpreadsheetColorIndex="9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xmlns:mc="http://schemas.openxmlformats.org/markup-compatibility/2006" val="000000" mc:Ignorable="a14" a14:legacySpreadsheetColorIndex="64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8288" tIns="18288" rIns="0" bIns="0" anchor="t" upright="1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altLang="ja-JP" sz="6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Years after registration</a:t>
            </a: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4174988" y="3541650"/>
            <a:ext cx="1386380" cy="27699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3-year EFS (95%CI)</a:t>
            </a:r>
          </a:p>
          <a:p>
            <a:pPr algn="ctr"/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: 37.1% (14.4-60.3%)</a:t>
            </a:r>
          </a:p>
        </p:txBody>
      </p:sp>
      <p:graphicFrame>
        <p:nvGraphicFramePr>
          <p:cNvPr id="48" name="グラフ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1710"/>
              </p:ext>
            </p:extLst>
          </p:nvPr>
        </p:nvGraphicFramePr>
        <p:xfrm>
          <a:off x="1015503" y="5084434"/>
          <a:ext cx="2209349" cy="20896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9" name="テキスト ボックス 48"/>
          <p:cNvSpPr txBox="1"/>
          <p:nvPr/>
        </p:nvSpPr>
        <p:spPr>
          <a:xfrm>
            <a:off x="1124433" y="7137211"/>
            <a:ext cx="2180318" cy="1529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591" dirty="0">
                <a:latin typeface="Arial" charset="0"/>
                <a:ea typeface="Arial" charset="0"/>
                <a:cs typeface="Arial" charset="0"/>
              </a:rPr>
              <a:t>35       34      22        10        7         3         1        0         0 </a:t>
            </a:r>
            <a:endParaRPr lang="ja-JP" altLang="en-US" sz="59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0" name="Text Box 1"/>
          <p:cNvSpPr txBox="1">
            <a:spLocks noChangeArrowheads="1"/>
          </p:cNvSpPr>
          <p:nvPr/>
        </p:nvSpPr>
        <p:spPr bwMode="auto">
          <a:xfrm>
            <a:off x="1729149" y="6984386"/>
            <a:ext cx="799120" cy="126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xmlns:mc="http://schemas.openxmlformats.org/markup-compatibility/2006" val="FFFFFF" mc:Ignorable="a14" a14:legacySpreadsheetColorIndex="9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xmlns:mc="http://schemas.openxmlformats.org/markup-compatibility/2006" val="000000" mc:Ignorable="a14" a14:legacySpreadsheetColorIndex="64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8288" tIns="18288" rIns="0" bIns="0" anchor="t" upright="1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altLang="ja-JP" sz="6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Years after registration</a:t>
            </a: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372577" y="5345768"/>
            <a:ext cx="1448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3-year TTLP (95%CI)</a:t>
            </a:r>
          </a:p>
          <a:p>
            <a:pPr algn="ctr"/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: 53.8% (23.9-76.5%)</a:t>
            </a:r>
          </a:p>
        </p:txBody>
      </p:sp>
      <p:graphicFrame>
        <p:nvGraphicFramePr>
          <p:cNvPr id="52" name="グラフ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1477030"/>
              </p:ext>
            </p:extLst>
          </p:nvPr>
        </p:nvGraphicFramePr>
        <p:xfrm>
          <a:off x="3904244" y="5070222"/>
          <a:ext cx="2136400" cy="2088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3" name="テキスト ボックス 52"/>
          <p:cNvSpPr txBox="1"/>
          <p:nvPr/>
        </p:nvSpPr>
        <p:spPr>
          <a:xfrm>
            <a:off x="4004096" y="7122221"/>
            <a:ext cx="2180318" cy="1529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591" dirty="0">
                <a:latin typeface="Arial" charset="0"/>
                <a:ea typeface="Arial" charset="0"/>
                <a:cs typeface="Arial" charset="0"/>
              </a:rPr>
              <a:t>35      34       22       11       7         3         1        0         0 </a:t>
            </a:r>
            <a:endParaRPr lang="ja-JP" altLang="en-US" sz="59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4246114" y="5333163"/>
            <a:ext cx="1085067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63" dirty="0">
                <a:latin typeface="Arial" charset="0"/>
                <a:ea typeface="Arial" charset="0"/>
                <a:cs typeface="Arial" charset="0"/>
              </a:rPr>
              <a:t>3-year TTDM (95%CI)</a:t>
            </a:r>
          </a:p>
          <a:p>
            <a:pPr algn="ctr"/>
            <a:r>
              <a:rPr lang="en-US" altLang="ja-JP" sz="563" dirty="0">
                <a:latin typeface="Arial" charset="0"/>
                <a:ea typeface="Arial" charset="0"/>
                <a:cs typeface="Arial" charset="0"/>
              </a:rPr>
              <a:t>: 15.2% (5.4-29.8%)</a:t>
            </a:r>
          </a:p>
        </p:txBody>
      </p:sp>
      <p:sp>
        <p:nvSpPr>
          <p:cNvPr id="55" name="Text Box 1"/>
          <p:cNvSpPr txBox="1">
            <a:spLocks noChangeArrowheads="1"/>
          </p:cNvSpPr>
          <p:nvPr/>
        </p:nvSpPr>
        <p:spPr bwMode="auto">
          <a:xfrm>
            <a:off x="4636712" y="6975784"/>
            <a:ext cx="799120" cy="126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xmlns:mc="http://schemas.openxmlformats.org/markup-compatibility/2006" val="FFFFFF" mc:Ignorable="a14" a14:legacySpreadsheetColorIndex="9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xmlns:mc="http://schemas.openxmlformats.org/markup-compatibility/2006" val="000000" mc:Ignorable="a14" a14:legacySpreadsheetColorIndex="64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8288" tIns="18288" rIns="0" bIns="0" anchor="t" upright="1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altLang="ja-JP" sz="6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Years after registration</a:t>
            </a:r>
          </a:p>
        </p:txBody>
      </p:sp>
    </p:spTree>
    <p:extLst>
      <p:ext uri="{BB962C8B-B14F-4D97-AF65-F5344CB8AC3E}">
        <p14:creationId xmlns:p14="http://schemas.microsoft.com/office/powerpoint/2010/main" val="18182786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円/楕円 1"/>
          <p:cNvSpPr/>
          <p:nvPr/>
        </p:nvSpPr>
        <p:spPr>
          <a:xfrm>
            <a:off x="2476633" y="2495201"/>
            <a:ext cx="1498667" cy="1542697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823978" y="2588451"/>
            <a:ext cx="777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b="1" u="sng" dirty="0">
                <a:latin typeface="Arial" charset="0"/>
                <a:ea typeface="Arial" charset="0"/>
                <a:cs typeface="Arial" charset="0"/>
              </a:rPr>
              <a:t>Loco-regional</a:t>
            </a:r>
          </a:p>
          <a:p>
            <a:pPr algn="ctr"/>
            <a:r>
              <a:rPr lang="en-US" altLang="ja-JP" sz="700" b="1" u="sng" dirty="0">
                <a:latin typeface="Arial" charset="0"/>
                <a:ea typeface="Arial" charset="0"/>
                <a:cs typeface="Arial" charset="0"/>
              </a:rPr>
              <a:t>disease</a:t>
            </a:r>
            <a:endParaRPr lang="ja-JP" altLang="en-US" sz="700" b="1" u="sng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816875" y="2603314"/>
            <a:ext cx="97975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u="sng">
                <a:latin typeface="Arial" charset="0"/>
                <a:ea typeface="Arial" charset="0"/>
                <a:cs typeface="Arial" charset="0"/>
              </a:rPr>
              <a:t>Distant metastasis</a:t>
            </a:r>
            <a:endParaRPr lang="ja-JP" altLang="en-US" sz="700" b="1" u="sng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037921" y="3152113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11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643171" y="3153988"/>
            <a:ext cx="3848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>
                <a:latin typeface="Arial" charset="0"/>
                <a:ea typeface="Arial" charset="0"/>
                <a:cs typeface="Arial" charset="0"/>
              </a:rPr>
              <a:t>2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206763" y="3146538"/>
            <a:ext cx="2248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>
                <a:latin typeface="Arial" charset="0"/>
                <a:ea typeface="Arial" charset="0"/>
                <a:cs typeface="Arial" charset="0"/>
              </a:rPr>
              <a:t>3</a:t>
            </a:r>
            <a:endParaRPr lang="ja-JP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93242" y="2877019"/>
            <a:ext cx="1820610" cy="83099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ja-JP" altLang="en-US" sz="600" dirty="0">
                <a:latin typeface="Arial" charset="0"/>
                <a:ea typeface="Arial" charset="0"/>
                <a:cs typeface="Arial" charset="0"/>
              </a:rPr>
              <a:t>■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Salvage surgery</a:t>
            </a:r>
            <a:r>
              <a:rPr lang="sk-SK" altLang="ja-JP" sz="600" baseline="30000" dirty="0">
                <a:latin typeface="Arial" charset="0"/>
              </a:rPr>
              <a:t>†</a:t>
            </a:r>
            <a:endParaRPr lang="en-US" altLang="ja-JP" sz="600" baseline="30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: 6 (37.5%)</a:t>
            </a:r>
          </a:p>
          <a:p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  </a:t>
            </a:r>
            <a:r>
              <a:rPr lang="ja-JP" altLang="en-US" sz="600" dirty="0"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Neck dissection for nodal recurrence (</a:t>
            </a:r>
            <a:r>
              <a:rPr lang="en-US" altLang="ja-JP" sz="600" i="1" dirty="0">
                <a:latin typeface="Arial" charset="0"/>
                <a:ea typeface="Arial" charset="0"/>
                <a:cs typeface="Arial" charset="0"/>
              </a:rPr>
              <a:t>n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=5)</a:t>
            </a:r>
          </a:p>
          <a:p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  </a:t>
            </a:r>
            <a:r>
              <a:rPr lang="ja-JP" altLang="en-US" sz="600" dirty="0"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Total laryngectomy for local recurrence of </a:t>
            </a:r>
            <a:br>
              <a:rPr lang="en-US" altLang="ja-JP" sz="600" dirty="0">
                <a:latin typeface="Arial" charset="0"/>
                <a:ea typeface="Arial" charset="0"/>
                <a:cs typeface="Arial" charset="0"/>
              </a:rPr>
            </a:b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     </a:t>
            </a:r>
            <a:r>
              <a:rPr lang="en-US" altLang="ja-JP" sz="600" dirty="0" err="1">
                <a:latin typeface="Arial" charset="0"/>
                <a:ea typeface="Arial" charset="0"/>
                <a:cs typeface="Arial" charset="0"/>
              </a:rPr>
              <a:t>hypopharyngeal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cancer(</a:t>
            </a:r>
            <a:r>
              <a:rPr lang="en-US" altLang="ja-JP" sz="600" i="1" dirty="0">
                <a:latin typeface="Arial" charset="0"/>
                <a:ea typeface="Arial" charset="0"/>
                <a:cs typeface="Arial" charset="0"/>
              </a:rPr>
              <a:t>n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=1)</a:t>
            </a:r>
            <a:br>
              <a:rPr lang="en-US" altLang="ja-JP" sz="600" dirty="0">
                <a:latin typeface="Arial" charset="0"/>
                <a:ea typeface="Arial" charset="0"/>
                <a:cs typeface="Arial" charset="0"/>
              </a:rPr>
            </a:br>
            <a:endParaRPr lang="ja-JP" altLang="en-US" sz="600" dirty="0">
              <a:latin typeface="Arial" charset="0"/>
              <a:ea typeface="Arial" charset="0"/>
              <a:cs typeface="Arial" charset="0"/>
            </a:endParaRPr>
          </a:p>
          <a:p>
            <a:r>
              <a:rPr lang="ja-JP" altLang="en-US" sz="600" dirty="0">
                <a:latin typeface="Arial" charset="0"/>
                <a:ea typeface="Arial" charset="0"/>
                <a:cs typeface="Arial" charset="0"/>
              </a:rPr>
              <a:t>■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Systemic chemotherapy</a:t>
            </a:r>
          </a:p>
          <a:p>
            <a:r>
              <a:rPr lang="ja-JP" altLang="en-US" sz="600" dirty="0">
                <a:latin typeface="Arial" charset="0"/>
                <a:ea typeface="Arial" charset="0"/>
                <a:cs typeface="Arial" charset="0"/>
              </a:rPr>
              <a:t>：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5 (31.2%)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136746" y="4308534"/>
            <a:ext cx="118241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ja-JP" altLang="en-US" sz="600" dirty="0">
                <a:latin typeface="Arial" charset="0"/>
                <a:ea typeface="Arial" charset="0"/>
                <a:cs typeface="Arial" charset="0"/>
              </a:rPr>
              <a:t>■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Systemic chemotherapy</a:t>
            </a:r>
          </a:p>
          <a:p>
            <a:r>
              <a:rPr lang="ja-JP" altLang="en-US" sz="600" dirty="0">
                <a:latin typeface="Arial" charset="0"/>
                <a:ea typeface="Arial" charset="0"/>
                <a:cs typeface="Arial" charset="0"/>
              </a:rPr>
              <a:t>：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2 (12.5%)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270438" y="3125878"/>
            <a:ext cx="118241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ja-JP" altLang="en-US" sz="600" dirty="0">
                <a:latin typeface="Arial" charset="0"/>
                <a:ea typeface="Arial" charset="0"/>
                <a:cs typeface="Arial" charset="0"/>
              </a:rPr>
              <a:t>■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 Systemic chemotherapy</a:t>
            </a:r>
          </a:p>
          <a:p>
            <a:r>
              <a:rPr lang="ja-JP" altLang="en-US" sz="600" dirty="0">
                <a:latin typeface="Arial" charset="0"/>
                <a:ea typeface="Arial" charset="0"/>
                <a:cs typeface="Arial" charset="0"/>
              </a:rPr>
              <a:t>：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3 (18.8%)</a:t>
            </a:r>
            <a:endParaRPr lang="ja-JP" altLang="en-US" sz="6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左矢印 10"/>
          <p:cNvSpPr/>
          <p:nvPr/>
        </p:nvSpPr>
        <p:spPr>
          <a:xfrm>
            <a:off x="2282220" y="3155057"/>
            <a:ext cx="358246" cy="222985"/>
          </a:xfrm>
          <a:prstGeom prst="leftArrow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円/楕円 11"/>
          <p:cNvSpPr/>
          <p:nvPr/>
        </p:nvSpPr>
        <p:spPr>
          <a:xfrm>
            <a:off x="3479338" y="2495356"/>
            <a:ext cx="1498667" cy="1542697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左矢印 12"/>
          <p:cNvSpPr/>
          <p:nvPr/>
        </p:nvSpPr>
        <p:spPr>
          <a:xfrm rot="10800000">
            <a:off x="4814172" y="3125878"/>
            <a:ext cx="342545" cy="237510"/>
          </a:xfrm>
          <a:prstGeom prst="leftArrow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左矢印 13"/>
          <p:cNvSpPr/>
          <p:nvPr/>
        </p:nvSpPr>
        <p:spPr>
          <a:xfrm rot="16200000">
            <a:off x="3371128" y="3782786"/>
            <a:ext cx="704132" cy="235506"/>
          </a:xfrm>
          <a:prstGeom prst="leftArrow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51504" y="1505139"/>
            <a:ext cx="36150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charset="0"/>
                <a:ea typeface="Arial" charset="0"/>
                <a:cs typeface="Arial" charset="0"/>
              </a:rPr>
              <a:t>Fig. S4. 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Status of first relapse and subsequent treatment among the FAS.  </a:t>
            </a:r>
            <a:endParaRPr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777701" y="4812516"/>
            <a:ext cx="380104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altLang="ja-JP" sz="600" baseline="30000" dirty="0">
                <a:latin typeface="Arial" charset="0"/>
              </a:rPr>
              <a:t>†</a:t>
            </a:r>
            <a:r>
              <a:rPr lang="en-US" altLang="ja-JP" sz="600" dirty="0">
                <a:latin typeface="Arial" charset="0"/>
                <a:ea typeface="Arial" charset="0"/>
                <a:cs typeface="Arial" charset="0"/>
              </a:rPr>
              <a:t>Including one patient who received salvage surgery at the time of CRT completion as protocol treatment. </a:t>
            </a:r>
            <a:endParaRPr lang="ja-JP" altLang="en-US" sz="6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030852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75</TotalTime>
  <Words>600</Words>
  <Application>Microsoft Macintosh PowerPoint</Application>
  <PresentationFormat>画面に合わせる (4:3)</PresentationFormat>
  <Paragraphs>247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榎田 智弘</cp:lastModifiedBy>
  <cp:revision>378</cp:revision>
  <dcterms:created xsi:type="dcterms:W3CDTF">2018-10-10T13:45:08Z</dcterms:created>
  <dcterms:modified xsi:type="dcterms:W3CDTF">2019-11-19T15:07:02Z</dcterms:modified>
</cp:coreProperties>
</file>